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22"/>
  </p:notesMasterIdLst>
  <p:sldIdLst>
    <p:sldId id="256" r:id="rId2"/>
    <p:sldId id="268" r:id="rId3"/>
    <p:sldId id="264" r:id="rId4"/>
    <p:sldId id="269" r:id="rId5"/>
    <p:sldId id="266" r:id="rId6"/>
    <p:sldId id="267" r:id="rId7"/>
    <p:sldId id="270" r:id="rId8"/>
    <p:sldId id="275" r:id="rId9"/>
    <p:sldId id="276" r:id="rId10"/>
    <p:sldId id="272" r:id="rId11"/>
    <p:sldId id="273" r:id="rId12"/>
    <p:sldId id="263" r:id="rId13"/>
    <p:sldId id="274" r:id="rId14"/>
    <p:sldId id="265" r:id="rId15"/>
    <p:sldId id="277" r:id="rId16"/>
    <p:sldId id="278" r:id="rId17"/>
    <p:sldId id="280" r:id="rId18"/>
    <p:sldId id="281" r:id="rId19"/>
    <p:sldId id="282" r:id="rId20"/>
    <p:sldId id="259" r:id="rId21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07" autoAdjust="0"/>
    <p:restoredTop sz="94056" autoAdjust="0"/>
  </p:normalViewPr>
  <p:slideViewPr>
    <p:cSldViewPr snapToGrid="0">
      <p:cViewPr varScale="1">
        <p:scale>
          <a:sx n="68" d="100"/>
          <a:sy n="68" d="100"/>
        </p:scale>
        <p:origin x="7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C8397D-A39B-4A0D-9C8B-E725EBF65FCC}" type="datetimeFigureOut">
              <a:rPr lang="zh-CN" altLang="en-US" smtClean="0"/>
              <a:t>2022/7/30 Saturday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7FF8CB-4CC2-4938-9D7F-C3293BB721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81238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7FF8CB-4CC2-4938-9D7F-C3293BB7211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72615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7FF8CB-4CC2-4938-9D7F-C3293BB72112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71158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7FF8CB-4CC2-4938-9D7F-C3293BB72112}" type="slidenum">
              <a:rPr lang="zh-CN" altLang="en-US" smtClean="0"/>
              <a:t>1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029372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7FF8CB-4CC2-4938-9D7F-C3293BB72112}" type="slidenum">
              <a:rPr lang="zh-CN" altLang="en-US" smtClean="0"/>
              <a:t>1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79987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EBC22-38EF-42B8-9174-2C77A5440E45}" type="datetimeFigureOut">
              <a:rPr lang="zh-CN" altLang="en-US" smtClean="0"/>
              <a:t>2022/7/30 Satur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92629-9941-4479-A505-AB0220D37E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2716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EBC22-38EF-42B8-9174-2C77A5440E45}" type="datetimeFigureOut">
              <a:rPr lang="zh-CN" altLang="en-US" smtClean="0"/>
              <a:t>2022/7/30 Satur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92629-9941-4479-A505-AB0220D37E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0027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EBC22-38EF-42B8-9174-2C77A5440E45}" type="datetimeFigureOut">
              <a:rPr lang="zh-CN" altLang="en-US" smtClean="0"/>
              <a:t>2022/7/30 Satur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92629-9941-4479-A505-AB0220D37E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18126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EBC22-38EF-42B8-9174-2C77A5440E45}" type="datetimeFigureOut">
              <a:rPr lang="zh-CN" altLang="en-US" smtClean="0"/>
              <a:t>2022/7/30 Satur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92629-9941-4479-A505-AB0220D37E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9573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EBC22-38EF-42B8-9174-2C77A5440E45}" type="datetimeFigureOut">
              <a:rPr lang="zh-CN" altLang="en-US" smtClean="0"/>
              <a:t>2022/7/30 Satur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92629-9941-4479-A505-AB0220D37E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6805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EBC22-38EF-42B8-9174-2C77A5440E45}" type="datetimeFigureOut">
              <a:rPr lang="zh-CN" altLang="en-US" smtClean="0"/>
              <a:t>2022/7/30 Satur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92629-9941-4479-A505-AB0220D37E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82025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EBC22-38EF-42B8-9174-2C77A5440E45}" type="datetimeFigureOut">
              <a:rPr lang="zh-CN" altLang="en-US" smtClean="0"/>
              <a:t>2022/7/30 Saturday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92629-9941-4479-A505-AB0220D37E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6097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EBC22-38EF-42B8-9174-2C77A5440E45}" type="datetimeFigureOut">
              <a:rPr lang="zh-CN" altLang="en-US" smtClean="0"/>
              <a:t>2022/7/30 Saturday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92629-9941-4479-A505-AB0220D37E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1763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EBC22-38EF-42B8-9174-2C77A5440E45}" type="datetimeFigureOut">
              <a:rPr lang="zh-CN" altLang="en-US" smtClean="0"/>
              <a:t>2022/7/30 Saturday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92629-9941-4479-A505-AB0220D37E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9141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EBC22-38EF-42B8-9174-2C77A5440E45}" type="datetimeFigureOut">
              <a:rPr lang="zh-CN" altLang="en-US" smtClean="0"/>
              <a:t>2022/7/30 Satur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92629-9941-4479-A505-AB0220D37E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17247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EBC22-38EF-42B8-9174-2C77A5440E45}" type="datetimeFigureOut">
              <a:rPr lang="zh-CN" altLang="en-US" smtClean="0"/>
              <a:t>2022/7/30 Satur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592629-9941-4479-A505-AB0220D37E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1554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1EBC22-38EF-42B8-9174-2C77A5440E45}" type="datetimeFigureOut">
              <a:rPr lang="zh-CN" altLang="en-US" smtClean="0"/>
              <a:t>2022/7/30 Satur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592629-9941-4479-A505-AB0220D37E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6663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jpeg"/><Relationship Id="rId3" Type="http://schemas.openxmlformats.org/officeDocument/2006/relationships/image" Target="../media/image49.tiff"/><Relationship Id="rId7" Type="http://schemas.openxmlformats.org/officeDocument/2006/relationships/image" Target="../media/image53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2.jpeg"/><Relationship Id="rId11" Type="http://schemas.openxmlformats.org/officeDocument/2006/relationships/image" Target="../media/image57.tiff"/><Relationship Id="rId5" Type="http://schemas.openxmlformats.org/officeDocument/2006/relationships/image" Target="../media/image51.tiff"/><Relationship Id="rId10" Type="http://schemas.openxmlformats.org/officeDocument/2006/relationships/image" Target="../media/image56.tiff"/><Relationship Id="rId4" Type="http://schemas.openxmlformats.org/officeDocument/2006/relationships/image" Target="../media/image50.tiff"/><Relationship Id="rId9" Type="http://schemas.openxmlformats.org/officeDocument/2006/relationships/image" Target="../media/image55.tif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jpeg"/><Relationship Id="rId3" Type="http://schemas.openxmlformats.org/officeDocument/2006/relationships/image" Target="../media/image58.jpeg"/><Relationship Id="rId7" Type="http://schemas.openxmlformats.org/officeDocument/2006/relationships/image" Target="../media/image62.jpeg"/><Relationship Id="rId12" Type="http://schemas.openxmlformats.org/officeDocument/2006/relationships/image" Target="../media/image67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1.jpeg"/><Relationship Id="rId11" Type="http://schemas.openxmlformats.org/officeDocument/2006/relationships/image" Target="../media/image66.jpeg"/><Relationship Id="rId5" Type="http://schemas.openxmlformats.org/officeDocument/2006/relationships/image" Target="../media/image60.jpeg"/><Relationship Id="rId10" Type="http://schemas.openxmlformats.org/officeDocument/2006/relationships/image" Target="../media/image65.jpeg"/><Relationship Id="rId4" Type="http://schemas.openxmlformats.org/officeDocument/2006/relationships/image" Target="../media/image59.jpeg"/><Relationship Id="rId9" Type="http://schemas.openxmlformats.org/officeDocument/2006/relationships/image" Target="../media/image64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jpeg"/><Relationship Id="rId7" Type="http://schemas.openxmlformats.org/officeDocument/2006/relationships/image" Target="../media/image73.jpeg"/><Relationship Id="rId2" Type="http://schemas.openxmlformats.org/officeDocument/2006/relationships/image" Target="../media/image6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2.jpeg"/><Relationship Id="rId5" Type="http://schemas.openxmlformats.org/officeDocument/2006/relationships/image" Target="../media/image71.tiff"/><Relationship Id="rId4" Type="http://schemas.openxmlformats.org/officeDocument/2006/relationships/image" Target="../media/image70.tiff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0.jpeg"/><Relationship Id="rId3" Type="http://schemas.openxmlformats.org/officeDocument/2006/relationships/image" Target="../media/image75.jpeg"/><Relationship Id="rId7" Type="http://schemas.openxmlformats.org/officeDocument/2006/relationships/image" Target="../media/image79.jpeg"/><Relationship Id="rId2" Type="http://schemas.openxmlformats.org/officeDocument/2006/relationships/image" Target="../media/image7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8.jpeg"/><Relationship Id="rId11" Type="http://schemas.openxmlformats.org/officeDocument/2006/relationships/image" Target="../media/image83.jpeg"/><Relationship Id="rId5" Type="http://schemas.openxmlformats.org/officeDocument/2006/relationships/image" Target="../media/image77.tiff"/><Relationship Id="rId10" Type="http://schemas.openxmlformats.org/officeDocument/2006/relationships/image" Target="../media/image82.jpeg"/><Relationship Id="rId4" Type="http://schemas.openxmlformats.org/officeDocument/2006/relationships/image" Target="../media/image76.jpeg"/><Relationship Id="rId9" Type="http://schemas.openxmlformats.org/officeDocument/2006/relationships/image" Target="../media/image81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5.jpeg"/><Relationship Id="rId7" Type="http://schemas.openxmlformats.org/officeDocument/2006/relationships/image" Target="../media/image89.jpeg"/><Relationship Id="rId2" Type="http://schemas.openxmlformats.org/officeDocument/2006/relationships/image" Target="../media/image8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8.jpeg"/><Relationship Id="rId5" Type="http://schemas.openxmlformats.org/officeDocument/2006/relationships/image" Target="../media/image87.tiff"/><Relationship Id="rId4" Type="http://schemas.openxmlformats.org/officeDocument/2006/relationships/image" Target="../media/image86.tif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1.tiff"/><Relationship Id="rId7" Type="http://schemas.openxmlformats.org/officeDocument/2006/relationships/image" Target="../media/image95.tiff"/><Relationship Id="rId2" Type="http://schemas.openxmlformats.org/officeDocument/2006/relationships/image" Target="../media/image9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4.tiff"/><Relationship Id="rId5" Type="http://schemas.openxmlformats.org/officeDocument/2006/relationships/image" Target="../media/image93.jpeg"/><Relationship Id="rId4" Type="http://schemas.openxmlformats.org/officeDocument/2006/relationships/image" Target="../media/image92.jpe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7.tiff"/><Relationship Id="rId7" Type="http://schemas.openxmlformats.org/officeDocument/2006/relationships/image" Target="../media/image101.jpeg"/><Relationship Id="rId2" Type="http://schemas.openxmlformats.org/officeDocument/2006/relationships/image" Target="../media/image9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0.jpeg"/><Relationship Id="rId5" Type="http://schemas.openxmlformats.org/officeDocument/2006/relationships/image" Target="../media/image99.jpeg"/><Relationship Id="rId4" Type="http://schemas.openxmlformats.org/officeDocument/2006/relationships/image" Target="../media/image98.jpe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3.tiff"/><Relationship Id="rId7" Type="http://schemas.openxmlformats.org/officeDocument/2006/relationships/image" Target="../media/image107.jpeg"/><Relationship Id="rId2" Type="http://schemas.openxmlformats.org/officeDocument/2006/relationships/image" Target="../media/image10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6.jpeg"/><Relationship Id="rId5" Type="http://schemas.openxmlformats.org/officeDocument/2006/relationships/image" Target="../media/image105.jpeg"/><Relationship Id="rId4" Type="http://schemas.openxmlformats.org/officeDocument/2006/relationships/image" Target="../media/image104.jpe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9.tiff"/><Relationship Id="rId7" Type="http://schemas.openxmlformats.org/officeDocument/2006/relationships/image" Target="../media/image113.tiff"/><Relationship Id="rId2" Type="http://schemas.openxmlformats.org/officeDocument/2006/relationships/image" Target="../media/image10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2.tiff"/><Relationship Id="rId5" Type="http://schemas.openxmlformats.org/officeDocument/2006/relationships/image" Target="../media/image111.tiff"/><Relationship Id="rId4" Type="http://schemas.openxmlformats.org/officeDocument/2006/relationships/image" Target="../media/image110.tif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5.jpeg"/><Relationship Id="rId7" Type="http://schemas.openxmlformats.org/officeDocument/2006/relationships/image" Target="../media/image119.jpeg"/><Relationship Id="rId2" Type="http://schemas.openxmlformats.org/officeDocument/2006/relationships/image" Target="../media/image11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8.jpeg"/><Relationship Id="rId5" Type="http://schemas.openxmlformats.org/officeDocument/2006/relationships/image" Target="../media/image117.jpeg"/><Relationship Id="rId4" Type="http://schemas.openxmlformats.org/officeDocument/2006/relationships/image" Target="../media/image116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tif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1.jpeg"/><Relationship Id="rId7" Type="http://schemas.openxmlformats.org/officeDocument/2006/relationships/image" Target="../media/image125.jpeg"/><Relationship Id="rId2" Type="http://schemas.openxmlformats.org/officeDocument/2006/relationships/image" Target="../media/image12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4.jpeg"/><Relationship Id="rId5" Type="http://schemas.openxmlformats.org/officeDocument/2006/relationships/image" Target="../media/image123.jpeg"/><Relationship Id="rId4" Type="http://schemas.openxmlformats.org/officeDocument/2006/relationships/image" Target="../media/image12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7" Type="http://schemas.openxmlformats.org/officeDocument/2006/relationships/image" Target="../media/image18.tiff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7" Type="http://schemas.openxmlformats.org/officeDocument/2006/relationships/image" Target="../media/image24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tiff"/><Relationship Id="rId3" Type="http://schemas.openxmlformats.org/officeDocument/2006/relationships/image" Target="../media/image25.tiff"/><Relationship Id="rId7" Type="http://schemas.openxmlformats.org/officeDocument/2006/relationships/image" Target="../media/image29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jpeg"/><Relationship Id="rId5" Type="http://schemas.openxmlformats.org/officeDocument/2006/relationships/image" Target="../media/image27.jpeg"/><Relationship Id="rId4" Type="http://schemas.openxmlformats.org/officeDocument/2006/relationships/image" Target="../media/image26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f"/><Relationship Id="rId7" Type="http://schemas.openxmlformats.org/officeDocument/2006/relationships/image" Target="../media/image36.jpeg"/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jpeg"/><Relationship Id="rId5" Type="http://schemas.openxmlformats.org/officeDocument/2006/relationships/image" Target="../media/image34.jpeg"/><Relationship Id="rId4" Type="http://schemas.openxmlformats.org/officeDocument/2006/relationships/image" Target="../media/image33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eg"/><Relationship Id="rId7" Type="http://schemas.openxmlformats.org/officeDocument/2006/relationships/image" Target="../media/image42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jpeg"/><Relationship Id="rId5" Type="http://schemas.openxmlformats.org/officeDocument/2006/relationships/image" Target="../media/image40.jpeg"/><Relationship Id="rId4" Type="http://schemas.openxmlformats.org/officeDocument/2006/relationships/image" Target="../media/image39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jpeg"/><Relationship Id="rId7" Type="http://schemas.openxmlformats.org/officeDocument/2006/relationships/image" Target="../media/image48.jpeg"/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jpeg"/><Relationship Id="rId5" Type="http://schemas.openxmlformats.org/officeDocument/2006/relationships/image" Target="../media/image46.jpeg"/><Relationship Id="rId4" Type="http://schemas.openxmlformats.org/officeDocument/2006/relationships/image" Target="../media/image4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52DF2834-45DE-FBE6-A708-CCF386DC2F5A}"/>
              </a:ext>
            </a:extLst>
          </p:cNvPr>
          <p:cNvGrpSpPr/>
          <p:nvPr/>
        </p:nvGrpSpPr>
        <p:grpSpPr>
          <a:xfrm>
            <a:off x="0" y="0"/>
            <a:ext cx="9987280" cy="6765511"/>
            <a:chOff x="0" y="0"/>
            <a:chExt cx="9987280" cy="6765511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AC24D9E5-6317-42EF-80EA-2FD35ABDFD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48030" y="720039"/>
              <a:ext cx="2888161" cy="1221980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354BCDC9-ECCD-4206-8777-AE6FFA6D9E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08531" y="624699"/>
              <a:ext cx="1685811" cy="1430867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56CEB179-90C4-4508-8A26-FB3E0FAC5F6F}"/>
                </a:ext>
              </a:extLst>
            </p:cNvPr>
            <p:cNvSpPr txBox="1"/>
            <p:nvPr/>
          </p:nvSpPr>
          <p:spPr>
            <a:xfrm>
              <a:off x="252848" y="1151472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44D3BADB-B10B-416C-9132-5EC58BEC2E16}"/>
                </a:ext>
              </a:extLst>
            </p:cNvPr>
            <p:cNvSpPr txBox="1"/>
            <p:nvPr/>
          </p:nvSpPr>
          <p:spPr>
            <a:xfrm>
              <a:off x="4852945" y="1151471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964F24A3-9022-494B-B940-F42108378549}"/>
                </a:ext>
              </a:extLst>
            </p:cNvPr>
            <p:cNvSpPr txBox="1"/>
            <p:nvPr/>
          </p:nvSpPr>
          <p:spPr>
            <a:xfrm>
              <a:off x="114300" y="0"/>
              <a:ext cx="137005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800" b="1" dirty="0">
                  <a:solidFill>
                    <a:srgbClr val="0000FF"/>
                  </a:solidFill>
                </a:rPr>
                <a:t>Figure 1</a:t>
              </a:r>
              <a:endParaRPr lang="zh-CN" altLang="en-US" sz="2800" b="1" dirty="0">
                <a:solidFill>
                  <a:srgbClr val="0000FF"/>
                </a:solidFill>
              </a:endParaRPr>
            </a:p>
          </p:txBody>
        </p:sp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E3FB2DCB-7858-10C4-865A-7F77A1BC6B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88693" y="2556021"/>
              <a:ext cx="2558752" cy="1221981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649A64DE-5A8B-AC30-0DFE-7934148120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88693" y="4262351"/>
              <a:ext cx="2451194" cy="1614557"/>
            </a:xfrm>
            <a:prstGeom prst="rect">
              <a:avLst/>
            </a:prstGeom>
          </p:spPr>
        </p:pic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EEF40B80-2492-6A0A-CC8F-2476B91CD3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61872" y="4370641"/>
              <a:ext cx="2730548" cy="1442767"/>
            </a:xfrm>
            <a:prstGeom prst="rect">
              <a:avLst/>
            </a:prstGeom>
          </p:spPr>
        </p:pic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25C71139-0942-9A88-DEEB-A11E8B6062BB}"/>
                </a:ext>
              </a:extLst>
            </p:cNvPr>
            <p:cNvSpPr txBox="1"/>
            <p:nvPr/>
          </p:nvSpPr>
          <p:spPr>
            <a:xfrm>
              <a:off x="123379" y="6396179"/>
              <a:ext cx="300082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Figure 1F Nfatc3 and GAPDH</a:t>
              </a:r>
              <a:endParaRPr lang="zh-CN" altLang="en-US" b="1" dirty="0"/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5963B1AF-C605-A775-C1AF-40727C586324}"/>
                </a:ext>
              </a:extLst>
            </p:cNvPr>
            <p:cNvSpPr txBox="1"/>
            <p:nvPr/>
          </p:nvSpPr>
          <p:spPr>
            <a:xfrm>
              <a:off x="250873" y="2883289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38E4CF58-2CB1-1F11-D839-BD360D4BB4F4}"/>
                </a:ext>
              </a:extLst>
            </p:cNvPr>
            <p:cNvSpPr txBox="1"/>
            <p:nvPr/>
          </p:nvSpPr>
          <p:spPr>
            <a:xfrm>
              <a:off x="4850970" y="2883288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86977CCA-9AB9-24EC-ECEA-D5D6E57323A3}"/>
                </a:ext>
              </a:extLst>
            </p:cNvPr>
            <p:cNvSpPr txBox="1"/>
            <p:nvPr/>
          </p:nvSpPr>
          <p:spPr>
            <a:xfrm>
              <a:off x="243056" y="4899703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CAA821E5-8931-8D53-D48A-061D007F6E11}"/>
                </a:ext>
              </a:extLst>
            </p:cNvPr>
            <p:cNvSpPr txBox="1"/>
            <p:nvPr/>
          </p:nvSpPr>
          <p:spPr>
            <a:xfrm>
              <a:off x="4843153" y="4899702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37DF8731-21B0-D744-100F-10DF9466DD75}"/>
                </a:ext>
              </a:extLst>
            </p:cNvPr>
            <p:cNvCxnSpPr/>
            <p:nvPr/>
          </p:nvCxnSpPr>
          <p:spPr>
            <a:xfrm>
              <a:off x="0" y="2263140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1B8CEA88-68DB-54BC-43EE-2DF6261D01B1}"/>
                </a:ext>
              </a:extLst>
            </p:cNvPr>
            <p:cNvCxnSpPr/>
            <p:nvPr/>
          </p:nvCxnSpPr>
          <p:spPr>
            <a:xfrm>
              <a:off x="0" y="4053840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C0C93CD1-2BDF-A921-40B5-4B7B520D41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08531" y="2615744"/>
              <a:ext cx="1962664" cy="122198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96435908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54712732-5EA6-8BBE-6260-679D85682D3F}"/>
              </a:ext>
            </a:extLst>
          </p:cNvPr>
          <p:cNvGrpSpPr/>
          <p:nvPr/>
        </p:nvGrpSpPr>
        <p:grpSpPr>
          <a:xfrm>
            <a:off x="-81280" y="729205"/>
            <a:ext cx="9987280" cy="6036306"/>
            <a:chOff x="-81280" y="729205"/>
            <a:chExt cx="9987280" cy="6036306"/>
          </a:xfrm>
        </p:grpSpPr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E7B35263-11EB-4F28-82A5-B64BB37B13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493957" y="751436"/>
              <a:ext cx="1449384" cy="1054099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DF9900FD-9364-4B7D-900D-E93D6E9CFC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49967" y="905838"/>
              <a:ext cx="1547595" cy="757633"/>
            </a:xfrm>
            <a:prstGeom prst="rect">
              <a:avLst/>
            </a:prstGeom>
          </p:spPr>
        </p:pic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CCF8D3B6-4F79-439B-8CBC-50E90030A1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753567" y="729205"/>
              <a:ext cx="1326632" cy="1054099"/>
            </a:xfrm>
            <a:prstGeom prst="rect">
              <a:avLst/>
            </a:prstGeom>
          </p:spPr>
        </p:pic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3559CD5D-3C8A-477A-AEDF-3DEFF797B593}"/>
                </a:ext>
              </a:extLst>
            </p:cNvPr>
            <p:cNvCxnSpPr/>
            <p:nvPr/>
          </p:nvCxnSpPr>
          <p:spPr>
            <a:xfrm>
              <a:off x="-81280" y="2267264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B716A87C-B749-4DC3-A160-E5EF00AA87D1}"/>
                </a:ext>
              </a:extLst>
            </p:cNvPr>
            <p:cNvSpPr txBox="1"/>
            <p:nvPr/>
          </p:nvSpPr>
          <p:spPr>
            <a:xfrm>
              <a:off x="249378" y="1069289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/>
                <a:t>iNOS</a:t>
              </a:r>
              <a:r>
                <a:rPr lang="en-US" altLang="zh-CN" sz="1600" dirty="0"/>
                <a:t> (130kD) </a:t>
              </a:r>
              <a:endParaRPr lang="zh-CN" altLang="en-US" sz="1600" dirty="0"/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9643B535-7737-493A-B6A8-65EB91692FEC}"/>
                </a:ext>
              </a:extLst>
            </p:cNvPr>
            <p:cNvSpPr txBox="1"/>
            <p:nvPr/>
          </p:nvSpPr>
          <p:spPr>
            <a:xfrm>
              <a:off x="6402675" y="1069289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38B5583D-632C-4A69-AD63-E803882D3223}"/>
                </a:ext>
              </a:extLst>
            </p:cNvPr>
            <p:cNvSpPr txBox="1"/>
            <p:nvPr/>
          </p:nvSpPr>
          <p:spPr>
            <a:xfrm>
              <a:off x="3203279" y="1069289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COX-2 (74kD) </a:t>
              </a:r>
              <a:endParaRPr lang="zh-CN" altLang="en-US" sz="1600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56538D12-0F8C-F574-43E1-D51F94FD1ABE}"/>
                </a:ext>
              </a:extLst>
            </p:cNvPr>
            <p:cNvSpPr txBox="1"/>
            <p:nvPr/>
          </p:nvSpPr>
          <p:spPr>
            <a:xfrm>
              <a:off x="123379" y="6396179"/>
              <a:ext cx="73697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Figure 3F </a:t>
              </a:r>
              <a:r>
                <a:rPr lang="en-US" altLang="zh-CN" b="1" dirty="0" err="1"/>
                <a:t>iNOS</a:t>
              </a:r>
              <a:r>
                <a:rPr lang="en-US" altLang="zh-CN" b="1" dirty="0"/>
                <a:t>, COX-2 and GAPDH (RAW264.7 cells)</a:t>
              </a:r>
              <a:endParaRPr lang="zh-CN" altLang="en-US" b="1" dirty="0"/>
            </a:p>
          </p:txBody>
        </p: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2F5BFBC8-24E6-D354-BD07-A96A3DDAF5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475822" y="2653530"/>
              <a:ext cx="1732117" cy="907066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44E04359-AF25-EB45-A04B-AF8F586E1C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49967" y="2639483"/>
              <a:ext cx="1428750" cy="907067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EADF48C6-6DB6-4625-81D7-D56E987F68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753567" y="2796984"/>
              <a:ext cx="1428750" cy="656997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9F6C90FE-CCF1-7D17-0462-5BD266446F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475822" y="4556885"/>
              <a:ext cx="1359717" cy="891106"/>
            </a:xfrm>
            <a:prstGeom prst="rect">
              <a:avLst/>
            </a:prstGeom>
          </p:spPr>
        </p:pic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1A6824B0-E104-FFC3-407A-AD25DF9253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60418" y="4324483"/>
              <a:ext cx="1590676" cy="1189649"/>
            </a:xfrm>
            <a:prstGeom prst="rect">
              <a:avLst/>
            </a:prstGeom>
          </p:spPr>
        </p:pic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D4C1B1EE-497C-09A1-E710-26D59005D8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753567" y="4442012"/>
              <a:ext cx="1485900" cy="913857"/>
            </a:xfrm>
            <a:prstGeom prst="rect">
              <a:avLst/>
            </a:prstGeom>
          </p:spPr>
        </p:pic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395DD6B8-E740-2DF7-23A6-41EEF594E905}"/>
                </a:ext>
              </a:extLst>
            </p:cNvPr>
            <p:cNvSpPr txBox="1"/>
            <p:nvPr/>
          </p:nvSpPr>
          <p:spPr>
            <a:xfrm>
              <a:off x="249378" y="3020734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/>
                <a:t>iNOS</a:t>
              </a:r>
              <a:r>
                <a:rPr lang="en-US" altLang="zh-CN" sz="1600" dirty="0"/>
                <a:t> (130kD) </a:t>
              </a:r>
              <a:endParaRPr lang="zh-CN" altLang="en-US" sz="1600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ECAAC539-3952-2E65-6C9D-ED30D562736E}"/>
                </a:ext>
              </a:extLst>
            </p:cNvPr>
            <p:cNvSpPr txBox="1"/>
            <p:nvPr/>
          </p:nvSpPr>
          <p:spPr>
            <a:xfrm>
              <a:off x="6402675" y="3020734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4EADBE0A-816D-465E-766F-1FF3228C53E6}"/>
                </a:ext>
              </a:extLst>
            </p:cNvPr>
            <p:cNvSpPr txBox="1"/>
            <p:nvPr/>
          </p:nvSpPr>
          <p:spPr>
            <a:xfrm>
              <a:off x="3203279" y="3020734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COX-2 (74kD) </a:t>
              </a:r>
              <a:endParaRPr lang="zh-CN" altLang="en-US" sz="1600" dirty="0"/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CD903134-B28C-FA34-C8C7-2550D2773295}"/>
                </a:ext>
              </a:extLst>
            </p:cNvPr>
            <p:cNvCxnSpPr/>
            <p:nvPr/>
          </p:nvCxnSpPr>
          <p:spPr>
            <a:xfrm>
              <a:off x="-81280" y="4046583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01A12325-F7E7-4100-118B-F1AA94D7CAE4}"/>
                </a:ext>
              </a:extLst>
            </p:cNvPr>
            <p:cNvSpPr txBox="1"/>
            <p:nvPr/>
          </p:nvSpPr>
          <p:spPr>
            <a:xfrm>
              <a:off x="249378" y="4825495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/>
                <a:t>iNOS</a:t>
              </a:r>
              <a:r>
                <a:rPr lang="en-US" altLang="zh-CN" sz="1600" dirty="0"/>
                <a:t> (130kD) </a:t>
              </a:r>
              <a:endParaRPr lang="zh-CN" altLang="en-US" sz="1600" dirty="0"/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032EA746-7B0B-4012-EAE8-C19CA51054FE}"/>
                </a:ext>
              </a:extLst>
            </p:cNvPr>
            <p:cNvSpPr txBox="1"/>
            <p:nvPr/>
          </p:nvSpPr>
          <p:spPr>
            <a:xfrm>
              <a:off x="6402675" y="4825495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63179C5C-D589-C314-B2B7-A827B4E20ADA}"/>
                </a:ext>
              </a:extLst>
            </p:cNvPr>
            <p:cNvSpPr txBox="1"/>
            <p:nvPr/>
          </p:nvSpPr>
          <p:spPr>
            <a:xfrm>
              <a:off x="3203279" y="4825495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COX-2 (74kD) </a:t>
              </a:r>
              <a:endParaRPr lang="zh-CN" alt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128874632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11BA3027-DB84-3B9D-0582-D601424B59A3}"/>
              </a:ext>
            </a:extLst>
          </p:cNvPr>
          <p:cNvGrpSpPr/>
          <p:nvPr/>
        </p:nvGrpSpPr>
        <p:grpSpPr>
          <a:xfrm>
            <a:off x="0" y="0"/>
            <a:ext cx="10101580" cy="6765511"/>
            <a:chOff x="0" y="0"/>
            <a:chExt cx="10101580" cy="6765511"/>
          </a:xfrm>
        </p:grpSpPr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9BF6858E-439B-51E7-6D08-EFD28CD63A0B}"/>
                </a:ext>
              </a:extLst>
            </p:cNvPr>
            <p:cNvSpPr txBox="1"/>
            <p:nvPr/>
          </p:nvSpPr>
          <p:spPr>
            <a:xfrm>
              <a:off x="114300" y="0"/>
              <a:ext cx="137005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800" b="1" dirty="0">
                  <a:solidFill>
                    <a:srgbClr val="0000FF"/>
                  </a:solidFill>
                </a:rPr>
                <a:t>Figure 4</a:t>
              </a:r>
              <a:endParaRPr lang="zh-CN" altLang="en-US" sz="2800" b="1" dirty="0">
                <a:solidFill>
                  <a:srgbClr val="0000FF"/>
                </a:solidFill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364F799C-27C3-592B-4A8A-365281854F42}"/>
                </a:ext>
              </a:extLst>
            </p:cNvPr>
            <p:cNvSpPr txBox="1"/>
            <p:nvPr/>
          </p:nvSpPr>
          <p:spPr>
            <a:xfrm>
              <a:off x="422716" y="808906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/>
                <a:t>iNOS</a:t>
              </a:r>
              <a:r>
                <a:rPr lang="en-US" altLang="zh-CN" sz="1600" dirty="0"/>
                <a:t> (130kD) </a:t>
              </a:r>
              <a:endParaRPr lang="zh-CN" altLang="en-US" sz="1600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BA50BC1E-9602-426B-DA0E-E5953AD61FF9}"/>
                </a:ext>
              </a:extLst>
            </p:cNvPr>
            <p:cNvSpPr txBox="1"/>
            <p:nvPr/>
          </p:nvSpPr>
          <p:spPr>
            <a:xfrm>
              <a:off x="5490863" y="858329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DE4DEF58-2940-F009-E6BC-46F0A4F00A2C}"/>
                </a:ext>
              </a:extLst>
            </p:cNvPr>
            <p:cNvSpPr txBox="1"/>
            <p:nvPr/>
          </p:nvSpPr>
          <p:spPr>
            <a:xfrm>
              <a:off x="123379" y="6396179"/>
              <a:ext cx="73697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Figure 4B </a:t>
              </a:r>
              <a:r>
                <a:rPr lang="en-US" altLang="zh-CN" b="1" dirty="0" err="1"/>
                <a:t>iNOS</a:t>
              </a:r>
              <a:r>
                <a:rPr lang="en-US" altLang="zh-CN" b="1" dirty="0"/>
                <a:t>,</a:t>
              </a:r>
              <a:r>
                <a:rPr lang="zh-CN" altLang="en-US" b="1" dirty="0"/>
                <a:t> </a:t>
              </a:r>
              <a:r>
                <a:rPr lang="en-US" altLang="zh-CN" b="1" dirty="0"/>
                <a:t>COX-2 and GAPDH (RAW264.7 cells)</a:t>
              </a:r>
              <a:endParaRPr lang="zh-CN" altLang="en-US" b="1" dirty="0"/>
            </a:p>
          </p:txBody>
        </p:sp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3DB3FEE4-0560-EC90-932E-452AA311EA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98940" y="427826"/>
              <a:ext cx="1994572" cy="1100713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96049B69-7DC0-59EA-5441-13EC712CA3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888571" y="535850"/>
              <a:ext cx="2788706" cy="1008193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C1A43B84-9CBA-D631-9E53-61BC31F3F4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95084" y="1654555"/>
              <a:ext cx="2019867" cy="760392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4E102D13-894F-057C-6AED-55F78716D6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888571" y="1847297"/>
              <a:ext cx="1447800" cy="561424"/>
            </a:xfrm>
            <a:prstGeom prst="rect">
              <a:avLst/>
            </a:prstGeom>
          </p:spPr>
        </p:pic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5333F877-8A68-10F6-BC8B-F8DD4FEC33A6}"/>
                </a:ext>
              </a:extLst>
            </p:cNvPr>
            <p:cNvSpPr txBox="1"/>
            <p:nvPr/>
          </p:nvSpPr>
          <p:spPr>
            <a:xfrm>
              <a:off x="394797" y="1865474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COX-2 (74kD) </a:t>
              </a:r>
              <a:endParaRPr lang="zh-CN" altLang="en-US" sz="1600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85C9341C-AF76-F051-C511-BBBA0B804B7B}"/>
                </a:ext>
              </a:extLst>
            </p:cNvPr>
            <p:cNvSpPr txBox="1"/>
            <p:nvPr/>
          </p:nvSpPr>
          <p:spPr>
            <a:xfrm>
              <a:off x="5490863" y="1987251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A6FE7736-D1E1-145A-2F50-064718EEE5B6}"/>
                </a:ext>
              </a:extLst>
            </p:cNvPr>
            <p:cNvSpPr txBox="1"/>
            <p:nvPr/>
          </p:nvSpPr>
          <p:spPr>
            <a:xfrm>
              <a:off x="299973" y="3315017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/>
                <a:t>iNOS</a:t>
              </a:r>
              <a:r>
                <a:rPr lang="en-US" altLang="zh-CN" sz="1600" dirty="0"/>
                <a:t> (130kD) </a:t>
              </a:r>
              <a:endParaRPr lang="zh-CN" altLang="en-US" sz="1600" dirty="0"/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1F7D672C-F2BD-AF71-B3E7-EB318EC94E94}"/>
                </a:ext>
              </a:extLst>
            </p:cNvPr>
            <p:cNvSpPr txBox="1"/>
            <p:nvPr/>
          </p:nvSpPr>
          <p:spPr>
            <a:xfrm>
              <a:off x="6547227" y="3321045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34" name="文本框 22">
              <a:extLst>
                <a:ext uri="{FF2B5EF4-FFF2-40B4-BE49-F238E27FC236}">
                  <a16:creationId xmlns:a16="http://schemas.microsoft.com/office/drawing/2014/main" id="{5333F877-8A68-10F6-BC8B-F8DD4FEC33A6}"/>
                </a:ext>
              </a:extLst>
            </p:cNvPr>
            <p:cNvSpPr txBox="1"/>
            <p:nvPr/>
          </p:nvSpPr>
          <p:spPr>
            <a:xfrm>
              <a:off x="3222910" y="3321045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600" dirty="0"/>
                <a:t>COX-2 (74kD) </a:t>
              </a:r>
              <a:endParaRPr lang="zh-CN" altLang="en-US" sz="1600" dirty="0"/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DA85E091-3592-9E41-AB50-7DB1E2C6ABEC}"/>
                </a:ext>
              </a:extLst>
            </p:cNvPr>
            <p:cNvSpPr txBox="1"/>
            <p:nvPr/>
          </p:nvSpPr>
          <p:spPr>
            <a:xfrm>
              <a:off x="335598" y="5214373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/>
                <a:t>iNOS</a:t>
              </a:r>
              <a:r>
                <a:rPr lang="en-US" altLang="zh-CN" sz="1600" dirty="0"/>
                <a:t> (130kD) </a:t>
              </a:r>
              <a:endParaRPr lang="zh-CN" altLang="en-US" sz="1600" dirty="0"/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D18A25D1-F078-E5AF-A795-4BA900945BA3}"/>
                </a:ext>
              </a:extLst>
            </p:cNvPr>
            <p:cNvSpPr txBox="1"/>
            <p:nvPr/>
          </p:nvSpPr>
          <p:spPr>
            <a:xfrm>
              <a:off x="6582852" y="5220401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37" name="文本框 22">
              <a:extLst>
                <a:ext uri="{FF2B5EF4-FFF2-40B4-BE49-F238E27FC236}">
                  <a16:creationId xmlns:a16="http://schemas.microsoft.com/office/drawing/2014/main" id="{FDB173FE-D1B9-8566-4CFF-55508A0223D4}"/>
                </a:ext>
              </a:extLst>
            </p:cNvPr>
            <p:cNvSpPr txBox="1"/>
            <p:nvPr/>
          </p:nvSpPr>
          <p:spPr>
            <a:xfrm>
              <a:off x="3307529" y="5231375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600" dirty="0"/>
                <a:t>COX-2 (74kD) </a:t>
              </a:r>
              <a:endParaRPr lang="zh-CN" altLang="en-US" sz="1600" dirty="0"/>
            </a:p>
          </p:txBody>
        </p: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5F785F2D-6432-106C-9920-0E4AD0C32CA0}"/>
                </a:ext>
              </a:extLst>
            </p:cNvPr>
            <p:cNvCxnSpPr/>
            <p:nvPr/>
          </p:nvCxnSpPr>
          <p:spPr>
            <a:xfrm>
              <a:off x="0" y="2801654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9" name="直接连接符 38">
              <a:extLst>
                <a:ext uri="{FF2B5EF4-FFF2-40B4-BE49-F238E27FC236}">
                  <a16:creationId xmlns:a16="http://schemas.microsoft.com/office/drawing/2014/main" id="{ADBD9C68-5C4F-9614-DDEE-6EAA691ABCC7}"/>
                </a:ext>
              </a:extLst>
            </p:cNvPr>
            <p:cNvCxnSpPr/>
            <p:nvPr/>
          </p:nvCxnSpPr>
          <p:spPr>
            <a:xfrm>
              <a:off x="114300" y="4580975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5DC64367-88A0-914F-2395-8A00C50769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41714" y="3021877"/>
              <a:ext cx="1681196" cy="1116217"/>
            </a:xfrm>
            <a:prstGeom prst="rect">
              <a:avLst/>
            </a:prstGeom>
          </p:spPr>
        </p:pic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B49E716C-3453-8145-3A73-35E39B2F95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42704" y="3140695"/>
              <a:ext cx="2008998" cy="789881"/>
            </a:xfrm>
            <a:prstGeom prst="rect">
              <a:avLst/>
            </a:prstGeom>
          </p:spPr>
        </p:pic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01F41339-057B-2B3F-3D2F-F829AA078B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896912" y="3005194"/>
              <a:ext cx="1351346" cy="1162408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C8296ED4-7ACC-DEC6-D183-56AF718DAA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41714" y="4771306"/>
              <a:ext cx="1731440" cy="1462091"/>
            </a:xfrm>
            <a:prstGeom prst="rect">
              <a:avLst/>
            </a:prstGeom>
          </p:spPr>
        </p:pic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4CE2B04D-23CD-377B-6832-5766C5F0BF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522803" y="4870288"/>
              <a:ext cx="1848800" cy="1264126"/>
            </a:xfrm>
            <a:prstGeom prst="rect">
              <a:avLst/>
            </a:prstGeom>
          </p:spPr>
        </p:pic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id="{60FB510F-37AC-409F-2BB5-F9BA331B49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945837" y="5082836"/>
              <a:ext cx="1731440" cy="79993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8741951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F9AAF60A-4E5B-9D7B-8016-F653971C82B6}"/>
              </a:ext>
            </a:extLst>
          </p:cNvPr>
          <p:cNvGrpSpPr/>
          <p:nvPr/>
        </p:nvGrpSpPr>
        <p:grpSpPr>
          <a:xfrm>
            <a:off x="-58808" y="0"/>
            <a:ext cx="10046088" cy="6765511"/>
            <a:chOff x="-58808" y="0"/>
            <a:chExt cx="10046088" cy="6765511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927F8F34-8A0A-47A0-B24E-FB01F9B4FF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825118" y="802790"/>
              <a:ext cx="1219200" cy="1026909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9A697B81-4D0C-4A42-A6D1-3C699204B7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26075" y="802789"/>
              <a:ext cx="1652527" cy="1026910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E528A81F-E889-4B6C-B4A9-CD0FBE63399D}"/>
                </a:ext>
              </a:extLst>
            </p:cNvPr>
            <p:cNvSpPr txBox="1"/>
            <p:nvPr/>
          </p:nvSpPr>
          <p:spPr>
            <a:xfrm>
              <a:off x="114300" y="0"/>
              <a:ext cx="137005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800" b="1" dirty="0">
                  <a:solidFill>
                    <a:srgbClr val="0000FF"/>
                  </a:solidFill>
                </a:rPr>
                <a:t>Figure 5</a:t>
              </a:r>
              <a:endParaRPr lang="zh-CN" altLang="en-US" sz="2800" b="1" dirty="0">
                <a:solidFill>
                  <a:srgbClr val="0000FF"/>
                </a:solidFill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5213E988-D388-44F0-A068-22B9BEF0C0B4}"/>
                </a:ext>
              </a:extLst>
            </p:cNvPr>
            <p:cNvSpPr txBox="1"/>
            <p:nvPr/>
          </p:nvSpPr>
          <p:spPr>
            <a:xfrm>
              <a:off x="4934832" y="1146968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A6262C05-0A2E-4406-BD1D-2EF2B1D640AB}"/>
                </a:ext>
              </a:extLst>
            </p:cNvPr>
            <p:cNvSpPr txBox="1"/>
            <p:nvPr/>
          </p:nvSpPr>
          <p:spPr>
            <a:xfrm>
              <a:off x="503152" y="1146970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DA52F32-FC65-D0C0-A103-D91313D50DE0}"/>
                </a:ext>
              </a:extLst>
            </p:cNvPr>
            <p:cNvSpPr txBox="1"/>
            <p:nvPr/>
          </p:nvSpPr>
          <p:spPr>
            <a:xfrm>
              <a:off x="123379" y="6396179"/>
              <a:ext cx="73697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Figure 5C Pou3f1 and GAPDH</a:t>
              </a:r>
              <a:endParaRPr lang="zh-CN" altLang="en-US" b="1" dirty="0"/>
            </a:p>
          </p:txBody>
        </p: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8F8F979D-8C75-CBC6-E31E-3D4A3A3134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825118" y="2481286"/>
              <a:ext cx="1959429" cy="1302778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8A3EA0CA-02D7-FAB4-9ACF-2837308989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26075" y="2544659"/>
              <a:ext cx="2315688" cy="1026910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851B5808-0272-46C8-A5B5-25B7DCE8B9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825118" y="4538550"/>
              <a:ext cx="1713729" cy="890649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13C79F86-552A-D0D5-5E5B-67E9908EBD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26075" y="4401983"/>
              <a:ext cx="1377381" cy="1163782"/>
            </a:xfrm>
            <a:prstGeom prst="rect">
              <a:avLst/>
            </a:prstGeom>
          </p:spPr>
        </p:pic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3E6EF5AC-609E-164A-9035-7EF8975CABC7}"/>
                </a:ext>
              </a:extLst>
            </p:cNvPr>
            <p:cNvSpPr txBox="1"/>
            <p:nvPr/>
          </p:nvSpPr>
          <p:spPr>
            <a:xfrm>
              <a:off x="4919484" y="2949374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9C368BC9-A8CD-658B-03D1-23E1CC379D79}"/>
                </a:ext>
              </a:extLst>
            </p:cNvPr>
            <p:cNvSpPr txBox="1"/>
            <p:nvPr/>
          </p:nvSpPr>
          <p:spPr>
            <a:xfrm>
              <a:off x="487804" y="2949376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AD39E6D4-2013-8737-3E33-8C74913349EA}"/>
                </a:ext>
              </a:extLst>
            </p:cNvPr>
            <p:cNvSpPr txBox="1"/>
            <p:nvPr/>
          </p:nvSpPr>
          <p:spPr>
            <a:xfrm>
              <a:off x="4919484" y="4830356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6105DB93-F39A-5CD8-2852-FA69142F7D52}"/>
                </a:ext>
              </a:extLst>
            </p:cNvPr>
            <p:cNvSpPr txBox="1"/>
            <p:nvPr/>
          </p:nvSpPr>
          <p:spPr>
            <a:xfrm>
              <a:off x="487804" y="4830358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30EC2B79-8C66-19AF-4FC4-62CD862273FE}"/>
                </a:ext>
              </a:extLst>
            </p:cNvPr>
            <p:cNvCxnSpPr/>
            <p:nvPr/>
          </p:nvCxnSpPr>
          <p:spPr>
            <a:xfrm>
              <a:off x="0" y="2163026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BEA1C38A-8A5F-B279-F766-ED946B9E9F09}"/>
                </a:ext>
              </a:extLst>
            </p:cNvPr>
            <p:cNvCxnSpPr/>
            <p:nvPr/>
          </p:nvCxnSpPr>
          <p:spPr>
            <a:xfrm>
              <a:off x="-58808" y="4115198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8617352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67BA763B-83A0-CDB1-F6C1-A874E4BB98E8}"/>
              </a:ext>
            </a:extLst>
          </p:cNvPr>
          <p:cNvGrpSpPr/>
          <p:nvPr/>
        </p:nvGrpSpPr>
        <p:grpSpPr>
          <a:xfrm>
            <a:off x="0" y="0"/>
            <a:ext cx="10001721" cy="6765511"/>
            <a:chOff x="0" y="0"/>
            <a:chExt cx="10001721" cy="6765511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28A60059-F02C-BAE5-5EB6-A42760BE6EAA}"/>
                </a:ext>
              </a:extLst>
            </p:cNvPr>
            <p:cNvSpPr txBox="1"/>
            <p:nvPr/>
          </p:nvSpPr>
          <p:spPr>
            <a:xfrm>
              <a:off x="114300" y="0"/>
              <a:ext cx="137005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800" b="1" dirty="0">
                  <a:solidFill>
                    <a:srgbClr val="0000FF"/>
                  </a:solidFill>
                </a:rPr>
                <a:t>Figure 6</a:t>
              </a:r>
              <a:endParaRPr lang="zh-CN" altLang="en-US" sz="2800" b="1" dirty="0">
                <a:solidFill>
                  <a:srgbClr val="0000FF"/>
                </a:solidFill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C399BE8B-A614-9299-11CC-94C6C5F711F6}"/>
                </a:ext>
              </a:extLst>
            </p:cNvPr>
            <p:cNvSpPr txBox="1"/>
            <p:nvPr/>
          </p:nvSpPr>
          <p:spPr>
            <a:xfrm>
              <a:off x="123379" y="6396179"/>
              <a:ext cx="73697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Figure 6F </a:t>
              </a:r>
              <a:r>
                <a:rPr lang="en-US" altLang="zh-CN" b="1" dirty="0" err="1"/>
                <a:t>iNOS</a:t>
              </a:r>
              <a:r>
                <a:rPr lang="en-US" altLang="zh-CN" b="1" dirty="0"/>
                <a:t>, COX-2 and GAPDH</a:t>
              </a:r>
              <a:endParaRPr lang="zh-CN" altLang="en-US" b="1" dirty="0"/>
            </a:p>
          </p:txBody>
        </p:sp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2D5A28CB-503E-EA38-0753-3025D4A21B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484355" y="716925"/>
              <a:ext cx="1727200" cy="551543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924C8618-1158-9935-6344-5E13999064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629321" y="766348"/>
              <a:ext cx="1530216" cy="551543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53296462-53D8-F154-F991-7F1715308B57}"/>
                </a:ext>
              </a:extLst>
            </p:cNvPr>
            <p:cNvSpPr txBox="1"/>
            <p:nvPr/>
          </p:nvSpPr>
          <p:spPr>
            <a:xfrm>
              <a:off x="222372" y="823420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/>
                <a:t>iNOS</a:t>
              </a:r>
              <a:r>
                <a:rPr lang="en-US" altLang="zh-CN" sz="1600" dirty="0"/>
                <a:t> (130kD) </a:t>
              </a:r>
              <a:endParaRPr lang="zh-CN" altLang="en-US" sz="1600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E93BCC3A-F8D7-6124-6646-070DD98CF62B}"/>
                </a:ext>
              </a:extLst>
            </p:cNvPr>
            <p:cNvSpPr txBox="1"/>
            <p:nvPr/>
          </p:nvSpPr>
          <p:spPr>
            <a:xfrm>
              <a:off x="5290519" y="872843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4ABEC609-68F0-E6FD-11D5-75424626925E}"/>
                </a:ext>
              </a:extLst>
            </p:cNvPr>
            <p:cNvSpPr txBox="1"/>
            <p:nvPr/>
          </p:nvSpPr>
          <p:spPr>
            <a:xfrm>
              <a:off x="194453" y="1879988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COX-2 (74kD) </a:t>
              </a:r>
              <a:endParaRPr lang="zh-CN" altLang="en-US" sz="1600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7D0E93A4-8A51-A1FB-EAD4-BCB9C5EB7C6F}"/>
                </a:ext>
              </a:extLst>
            </p:cNvPr>
            <p:cNvSpPr txBox="1"/>
            <p:nvPr/>
          </p:nvSpPr>
          <p:spPr>
            <a:xfrm>
              <a:off x="5290519" y="2001765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EE4A1DDC-8884-D682-2DF4-80B9DECA32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484355" y="1447660"/>
              <a:ext cx="1370056" cy="1143019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6FCD23AC-C31A-FF00-99F0-2CC37A65C8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650903" y="1473445"/>
              <a:ext cx="1370056" cy="1056640"/>
            </a:xfrm>
            <a:prstGeom prst="rect">
              <a:avLst/>
            </a:prstGeom>
          </p:spPr>
        </p:pic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79978052-2110-4683-C6A4-A7CB4B13426B}"/>
                </a:ext>
              </a:extLst>
            </p:cNvPr>
            <p:cNvSpPr txBox="1"/>
            <p:nvPr/>
          </p:nvSpPr>
          <p:spPr>
            <a:xfrm>
              <a:off x="222372" y="3491495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/>
                <a:t>iNOS</a:t>
              </a:r>
              <a:r>
                <a:rPr lang="en-US" altLang="zh-CN" sz="1600" dirty="0"/>
                <a:t> (130kD) </a:t>
              </a:r>
              <a:endParaRPr lang="zh-CN" altLang="en-US" sz="1600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F88FF21F-33CF-BFEB-48C0-1C10456B4387}"/>
                </a:ext>
              </a:extLst>
            </p:cNvPr>
            <p:cNvSpPr txBox="1"/>
            <p:nvPr/>
          </p:nvSpPr>
          <p:spPr>
            <a:xfrm>
              <a:off x="6579112" y="3509730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17" name="文本框 22">
              <a:extLst>
                <a:ext uri="{FF2B5EF4-FFF2-40B4-BE49-F238E27FC236}">
                  <a16:creationId xmlns:a16="http://schemas.microsoft.com/office/drawing/2014/main" id="{7A21C58B-41AE-FD7F-8442-5CE1448F00EA}"/>
                </a:ext>
              </a:extLst>
            </p:cNvPr>
            <p:cNvSpPr txBox="1"/>
            <p:nvPr/>
          </p:nvSpPr>
          <p:spPr>
            <a:xfrm>
              <a:off x="3460485" y="3466244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600" dirty="0"/>
                <a:t>COX-2 (74kD) </a:t>
              </a:r>
              <a:endParaRPr lang="zh-CN" altLang="en-US" sz="1600" dirty="0"/>
            </a:p>
          </p:txBody>
        </p:sp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03F2D7FD-A852-AA09-44CC-7C71B75DEF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484355" y="3198098"/>
              <a:ext cx="1648310" cy="892862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DA6CAEAD-BEC4-267B-D1CC-346D1653C4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711712" y="3198098"/>
              <a:ext cx="1635171" cy="924050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8153A292-1A59-4968-C0DB-F10A351A90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917914" y="3198098"/>
              <a:ext cx="1370057" cy="900651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CE4076B7-0C97-A746-42E6-01AE1FDCAF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484355" y="4869154"/>
              <a:ext cx="1547596" cy="1143019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1AC9BE0A-327F-82AE-E5E7-FD5D95F35D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711712" y="5035079"/>
              <a:ext cx="1775461" cy="811167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606E51F4-3D85-077F-50E0-D7F89C4356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917914" y="4919428"/>
              <a:ext cx="919163" cy="989806"/>
            </a:xfrm>
            <a:prstGeom prst="rect">
              <a:avLst/>
            </a:prstGeom>
          </p:spPr>
        </p:pic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ACBE2B48-7244-1828-9FB1-3D0D3D83C532}"/>
                </a:ext>
              </a:extLst>
            </p:cNvPr>
            <p:cNvSpPr txBox="1"/>
            <p:nvPr/>
          </p:nvSpPr>
          <p:spPr>
            <a:xfrm>
              <a:off x="248702" y="5243162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 err="1"/>
                <a:t>iNOS</a:t>
              </a:r>
              <a:r>
                <a:rPr lang="en-US" altLang="zh-CN" sz="1600" dirty="0"/>
                <a:t> (130kD) </a:t>
              </a:r>
              <a:endParaRPr lang="zh-CN" altLang="en-US" sz="1600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E6B7FBEE-4FF2-5333-C1BF-73867AB8F5CF}"/>
                </a:ext>
              </a:extLst>
            </p:cNvPr>
            <p:cNvSpPr txBox="1"/>
            <p:nvPr/>
          </p:nvSpPr>
          <p:spPr>
            <a:xfrm>
              <a:off x="6605442" y="5261397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30" name="文本框 22">
              <a:extLst>
                <a:ext uri="{FF2B5EF4-FFF2-40B4-BE49-F238E27FC236}">
                  <a16:creationId xmlns:a16="http://schemas.microsoft.com/office/drawing/2014/main" id="{89B70125-F1CB-0CA0-D508-1BB0FC4DD17E}"/>
                </a:ext>
              </a:extLst>
            </p:cNvPr>
            <p:cNvSpPr txBox="1"/>
            <p:nvPr/>
          </p:nvSpPr>
          <p:spPr>
            <a:xfrm>
              <a:off x="3486815" y="5217911"/>
              <a:ext cx="15475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600" dirty="0"/>
                <a:t>COX-2 (74kD) </a:t>
              </a:r>
              <a:endParaRPr lang="zh-CN" altLang="en-US" sz="1600" dirty="0"/>
            </a:p>
          </p:txBody>
        </p: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91C75EB5-82B4-8D48-A08A-76D9E6E83D85}"/>
                </a:ext>
              </a:extLst>
            </p:cNvPr>
            <p:cNvCxnSpPr/>
            <p:nvPr/>
          </p:nvCxnSpPr>
          <p:spPr>
            <a:xfrm>
              <a:off x="14441" y="2937726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id="{755589D2-B99A-AE08-D894-28B166C67284}"/>
                </a:ext>
              </a:extLst>
            </p:cNvPr>
            <p:cNvCxnSpPr/>
            <p:nvPr/>
          </p:nvCxnSpPr>
          <p:spPr>
            <a:xfrm>
              <a:off x="0" y="4576026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7220047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A287B74A-B24F-DFF9-4D42-034E6258ED3C}"/>
              </a:ext>
            </a:extLst>
          </p:cNvPr>
          <p:cNvGrpSpPr/>
          <p:nvPr/>
        </p:nvGrpSpPr>
        <p:grpSpPr>
          <a:xfrm>
            <a:off x="-81280" y="0"/>
            <a:ext cx="10027920" cy="6765511"/>
            <a:chOff x="-81280" y="0"/>
            <a:chExt cx="10027920" cy="6765511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CC552B2C-3A57-4339-BA94-088F8F113C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31600" y="912698"/>
              <a:ext cx="1949621" cy="816100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A5E4E918-6CE2-4CF4-BA0D-A3B912087E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198328" y="744074"/>
              <a:ext cx="1474292" cy="1254252"/>
            </a:xfrm>
            <a:prstGeom prst="rect">
              <a:avLst/>
            </a:prstGeom>
          </p:spPr>
        </p:pic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50F887E1-7B6B-44CF-A947-1BBF115AA886}"/>
                </a:ext>
              </a:extLst>
            </p:cNvPr>
            <p:cNvCxnSpPr/>
            <p:nvPr/>
          </p:nvCxnSpPr>
          <p:spPr>
            <a:xfrm>
              <a:off x="-40640" y="2218690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F3332DF4-902D-1721-51C0-CF162130C969}"/>
                </a:ext>
              </a:extLst>
            </p:cNvPr>
            <p:cNvSpPr txBox="1"/>
            <p:nvPr/>
          </p:nvSpPr>
          <p:spPr>
            <a:xfrm>
              <a:off x="114300" y="0"/>
              <a:ext cx="372922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800" b="1" dirty="0">
                  <a:solidFill>
                    <a:srgbClr val="0000FF"/>
                  </a:solidFill>
                </a:rPr>
                <a:t>Supplementary Figure 1</a:t>
              </a:r>
              <a:endParaRPr lang="zh-CN" altLang="en-US" sz="2800" b="1" dirty="0">
                <a:solidFill>
                  <a:srgbClr val="0000FF"/>
                </a:solidFill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6F2CAE86-F43E-3837-EC5C-AD6533AB7D42}"/>
                </a:ext>
              </a:extLst>
            </p:cNvPr>
            <p:cNvSpPr txBox="1"/>
            <p:nvPr/>
          </p:nvSpPr>
          <p:spPr>
            <a:xfrm>
              <a:off x="123379" y="6396179"/>
              <a:ext cx="73697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 err="1"/>
                <a:t>sFigure</a:t>
              </a:r>
              <a:r>
                <a:rPr lang="en-US" altLang="zh-CN" b="1" dirty="0"/>
                <a:t> 1B Nfatc3 and GAPDH (RAW264.7 cells)</a:t>
              </a:r>
              <a:endParaRPr lang="zh-CN" altLang="en-US" b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55AC9409-61CC-A0C7-1534-F5B0892E3F0B}"/>
                </a:ext>
              </a:extLst>
            </p:cNvPr>
            <p:cNvSpPr txBox="1"/>
            <p:nvPr/>
          </p:nvSpPr>
          <p:spPr>
            <a:xfrm>
              <a:off x="252848" y="1151472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9A7A950A-D93B-0CE2-ABEF-82B83BF0E196}"/>
                </a:ext>
              </a:extLst>
            </p:cNvPr>
            <p:cNvSpPr txBox="1"/>
            <p:nvPr/>
          </p:nvSpPr>
          <p:spPr>
            <a:xfrm>
              <a:off x="4852945" y="1151471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4A519E39-F222-47EF-6D5E-F69E1637A5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26581" y="2403565"/>
              <a:ext cx="1485010" cy="1627788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D08FE3EA-E360-EA1D-9904-C06B4D4406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14936" y="2364940"/>
              <a:ext cx="2246183" cy="1627788"/>
            </a:xfrm>
            <a:prstGeom prst="rect">
              <a:avLst/>
            </a:prstGeom>
          </p:spPr>
        </p:pic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4835ABA3-1FDB-3D1A-C338-6B740182A5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26581" y="4708951"/>
              <a:ext cx="3027487" cy="1202832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A29E7C5F-A989-F062-1891-58E9E7030A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14936" y="4484098"/>
              <a:ext cx="2020626" cy="1733044"/>
            </a:xfrm>
            <a:prstGeom prst="rect">
              <a:avLst/>
            </a:prstGeom>
          </p:spPr>
        </p:pic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4E5AF372-618F-8C01-8F1B-67DF8EA5E67A}"/>
                </a:ext>
              </a:extLst>
            </p:cNvPr>
            <p:cNvCxnSpPr/>
            <p:nvPr/>
          </p:nvCxnSpPr>
          <p:spPr>
            <a:xfrm>
              <a:off x="-81280" y="4305062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2B3D770A-DBAC-2954-51C2-BB7D788D2F89}"/>
                </a:ext>
              </a:extLst>
            </p:cNvPr>
            <p:cNvSpPr txBox="1"/>
            <p:nvPr/>
          </p:nvSpPr>
          <p:spPr>
            <a:xfrm>
              <a:off x="252848" y="3016219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AAC47F93-FABF-6204-5B4E-E44BBDE23EF7}"/>
                </a:ext>
              </a:extLst>
            </p:cNvPr>
            <p:cNvSpPr txBox="1"/>
            <p:nvPr/>
          </p:nvSpPr>
          <p:spPr>
            <a:xfrm>
              <a:off x="4852945" y="3016218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CF0D894C-CAB6-4531-5D25-4F74BCA4A6E1}"/>
                </a:ext>
              </a:extLst>
            </p:cNvPr>
            <p:cNvSpPr txBox="1"/>
            <p:nvPr/>
          </p:nvSpPr>
          <p:spPr>
            <a:xfrm>
              <a:off x="252848" y="5181344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DC9EDB56-C6D0-6F7D-9B01-E1C93E48DD53}"/>
                </a:ext>
              </a:extLst>
            </p:cNvPr>
            <p:cNvSpPr txBox="1"/>
            <p:nvPr/>
          </p:nvSpPr>
          <p:spPr>
            <a:xfrm>
              <a:off x="4852945" y="5181343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52877804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96D7247F-509D-C601-E5C6-E880E899ABAC}"/>
              </a:ext>
            </a:extLst>
          </p:cNvPr>
          <p:cNvGrpSpPr/>
          <p:nvPr/>
        </p:nvGrpSpPr>
        <p:grpSpPr>
          <a:xfrm>
            <a:off x="-81280" y="658340"/>
            <a:ext cx="10027920" cy="6107171"/>
            <a:chOff x="-81280" y="658340"/>
            <a:chExt cx="10027920" cy="6107171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2A6A2532-D324-29AA-C3F3-109AA7B82C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90825" y="658340"/>
              <a:ext cx="1486133" cy="1374794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2A618C62-CB6F-77BA-5778-A8F0AEF834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57507" y="707679"/>
              <a:ext cx="1957668" cy="1325455"/>
            </a:xfrm>
            <a:prstGeom prst="rect">
              <a:avLst/>
            </a:prstGeom>
          </p:spPr>
        </p:pic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7D8303C3-306E-A9E7-DDED-A04ED7680276}"/>
                </a:ext>
              </a:extLst>
            </p:cNvPr>
            <p:cNvSpPr txBox="1"/>
            <p:nvPr/>
          </p:nvSpPr>
          <p:spPr>
            <a:xfrm>
              <a:off x="123379" y="6396179"/>
              <a:ext cx="73697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 err="1"/>
                <a:t>sFigure</a:t>
              </a:r>
              <a:r>
                <a:rPr lang="en-US" altLang="zh-CN" b="1" dirty="0"/>
                <a:t> 1B Nfatc3 and GAPDH (BMDMs)</a:t>
              </a:r>
              <a:endParaRPr lang="zh-CN" altLang="en-US" b="1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828B841E-FB18-BA88-0C8E-D4F19220A94E}"/>
                </a:ext>
              </a:extLst>
            </p:cNvPr>
            <p:cNvSpPr txBox="1"/>
            <p:nvPr/>
          </p:nvSpPr>
          <p:spPr>
            <a:xfrm>
              <a:off x="252848" y="1151472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91DAD2D4-28B1-3FF4-7A03-B41F68AB46E7}"/>
                </a:ext>
              </a:extLst>
            </p:cNvPr>
            <p:cNvSpPr txBox="1"/>
            <p:nvPr/>
          </p:nvSpPr>
          <p:spPr>
            <a:xfrm>
              <a:off x="4852945" y="1151471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DA463CD4-0C54-2180-7396-2AA2EAD19761}"/>
                </a:ext>
              </a:extLst>
            </p:cNvPr>
            <p:cNvCxnSpPr/>
            <p:nvPr/>
          </p:nvCxnSpPr>
          <p:spPr>
            <a:xfrm>
              <a:off x="-40640" y="2218690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id="{D00194C6-77C7-387F-44DE-E7AA34F7A86F}"/>
                </a:ext>
              </a:extLst>
            </p:cNvPr>
            <p:cNvCxnSpPr/>
            <p:nvPr/>
          </p:nvCxnSpPr>
          <p:spPr>
            <a:xfrm>
              <a:off x="-81280" y="4305062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485B3682-C7F5-48CC-7B4E-3AEE75B73D39}"/>
                </a:ext>
              </a:extLst>
            </p:cNvPr>
            <p:cNvSpPr txBox="1"/>
            <p:nvPr/>
          </p:nvSpPr>
          <p:spPr>
            <a:xfrm>
              <a:off x="252848" y="3016219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C44B81C8-E7BC-ACF1-AE73-8D725CE1B43F}"/>
                </a:ext>
              </a:extLst>
            </p:cNvPr>
            <p:cNvSpPr txBox="1"/>
            <p:nvPr/>
          </p:nvSpPr>
          <p:spPr>
            <a:xfrm>
              <a:off x="4852945" y="3016218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FD41CA7F-4ECE-B32F-E384-F393EAF795B8}"/>
                </a:ext>
              </a:extLst>
            </p:cNvPr>
            <p:cNvSpPr txBox="1"/>
            <p:nvPr/>
          </p:nvSpPr>
          <p:spPr>
            <a:xfrm>
              <a:off x="252848" y="5181344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2302627B-FF74-67CB-0322-AD67EAAB5C81}"/>
                </a:ext>
              </a:extLst>
            </p:cNvPr>
            <p:cNvSpPr txBox="1"/>
            <p:nvPr/>
          </p:nvSpPr>
          <p:spPr>
            <a:xfrm>
              <a:off x="4852945" y="5181343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A333CEED-4BA0-F034-5815-FC6CCA6097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14466" y="4529111"/>
              <a:ext cx="2767000" cy="1759946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3CD9BDDE-68AC-7805-0EE3-01728C9AD6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57506" y="4470985"/>
              <a:ext cx="1404891" cy="1915298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91804102-8873-2D39-1A5E-AF2EDE4866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90825" y="2558018"/>
              <a:ext cx="1957668" cy="1505693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E4A6AA1B-5B70-AFD5-2665-29DA57747B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17217" y="2693718"/>
              <a:ext cx="1655802" cy="95052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05862007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B892175E-07BB-604F-BA73-764C21CFF164}"/>
              </a:ext>
            </a:extLst>
          </p:cNvPr>
          <p:cNvGrpSpPr/>
          <p:nvPr/>
        </p:nvGrpSpPr>
        <p:grpSpPr>
          <a:xfrm>
            <a:off x="-81280" y="0"/>
            <a:ext cx="10027920" cy="6765511"/>
            <a:chOff x="-81280" y="0"/>
            <a:chExt cx="10027920" cy="6765511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18257973-54EF-A84A-C084-4D10618F61E9}"/>
                </a:ext>
              </a:extLst>
            </p:cNvPr>
            <p:cNvSpPr txBox="1"/>
            <p:nvPr/>
          </p:nvSpPr>
          <p:spPr>
            <a:xfrm>
              <a:off x="114300" y="0"/>
              <a:ext cx="372922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800" b="1" dirty="0">
                  <a:solidFill>
                    <a:srgbClr val="0000FF"/>
                  </a:solidFill>
                </a:rPr>
                <a:t>Supplementary Figure 2</a:t>
              </a:r>
              <a:endParaRPr lang="zh-CN" altLang="en-US" sz="2800" b="1" dirty="0">
                <a:solidFill>
                  <a:srgbClr val="0000FF"/>
                </a:solidFill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5C9D3635-9618-3628-A35E-F517DC00C354}"/>
                </a:ext>
              </a:extLst>
            </p:cNvPr>
            <p:cNvSpPr txBox="1"/>
            <p:nvPr/>
          </p:nvSpPr>
          <p:spPr>
            <a:xfrm>
              <a:off x="123379" y="6396179"/>
              <a:ext cx="73697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 err="1"/>
                <a:t>sFigure</a:t>
              </a:r>
              <a:r>
                <a:rPr lang="en-US" altLang="zh-CN" b="1" dirty="0"/>
                <a:t> 2A Nfatc3 and Histone H3 (RAW264.7 cells)</a:t>
              </a:r>
              <a:endParaRPr lang="zh-CN" altLang="en-US" b="1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FE4CED71-7EB9-ECD3-5761-CB8685FAAD2F}"/>
                </a:ext>
              </a:extLst>
            </p:cNvPr>
            <p:cNvSpPr txBox="1"/>
            <p:nvPr/>
          </p:nvSpPr>
          <p:spPr>
            <a:xfrm>
              <a:off x="252848" y="1151472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E1B1CA4A-4D62-9322-6FBA-12A86A5AEBB5}"/>
                </a:ext>
              </a:extLst>
            </p:cNvPr>
            <p:cNvSpPr txBox="1"/>
            <p:nvPr/>
          </p:nvSpPr>
          <p:spPr>
            <a:xfrm>
              <a:off x="4852945" y="1151471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Histone H3 (15kD)</a:t>
              </a:r>
              <a:endParaRPr lang="zh-CN" altLang="en-US" sz="1600" dirty="0"/>
            </a:p>
          </p:txBody>
        </p: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EBAAE0CA-9B00-F2BB-F888-E76D82A5FACD}"/>
                </a:ext>
              </a:extLst>
            </p:cNvPr>
            <p:cNvCxnSpPr/>
            <p:nvPr/>
          </p:nvCxnSpPr>
          <p:spPr>
            <a:xfrm>
              <a:off x="-40640" y="2218690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A628F266-253C-3BE4-EA5E-1B193C607BBE}"/>
                </a:ext>
              </a:extLst>
            </p:cNvPr>
            <p:cNvCxnSpPr/>
            <p:nvPr/>
          </p:nvCxnSpPr>
          <p:spPr>
            <a:xfrm>
              <a:off x="-81280" y="4305062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3DC127EC-14C0-651F-2047-542C90EFCBDB}"/>
                </a:ext>
              </a:extLst>
            </p:cNvPr>
            <p:cNvSpPr txBox="1"/>
            <p:nvPr/>
          </p:nvSpPr>
          <p:spPr>
            <a:xfrm>
              <a:off x="252848" y="3016219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493B41DD-402D-F60B-2A00-ECB4CE977D1D}"/>
                </a:ext>
              </a:extLst>
            </p:cNvPr>
            <p:cNvSpPr txBox="1"/>
            <p:nvPr/>
          </p:nvSpPr>
          <p:spPr>
            <a:xfrm>
              <a:off x="4852945" y="3016218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Histone H3 (15kD)</a:t>
              </a:r>
              <a:endParaRPr lang="zh-CN" altLang="en-US" sz="1600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A79827B-38A5-DB5E-7036-5D83FD5191E4}"/>
                </a:ext>
              </a:extLst>
            </p:cNvPr>
            <p:cNvSpPr txBox="1"/>
            <p:nvPr/>
          </p:nvSpPr>
          <p:spPr>
            <a:xfrm>
              <a:off x="252848" y="5181344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D25B211-3346-A040-585C-1A3375455CB2}"/>
                </a:ext>
              </a:extLst>
            </p:cNvPr>
            <p:cNvSpPr txBox="1"/>
            <p:nvPr/>
          </p:nvSpPr>
          <p:spPr>
            <a:xfrm>
              <a:off x="4852945" y="5181343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Histone H3 (15kD)</a:t>
              </a:r>
              <a:endParaRPr lang="zh-CN" altLang="en-US" sz="1600" dirty="0"/>
            </a:p>
          </p:txBody>
        </p:sp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5ACE07EE-1AC1-7F77-7C89-FEC8B4BDBC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69144" y="681527"/>
              <a:ext cx="2632260" cy="1378856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B0C368AC-ECA8-4DC5-EEB6-8DACB895B2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519451" y="789292"/>
              <a:ext cx="1775461" cy="1062911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54ABC127-B8E4-3E2C-4F5D-15E46E78C8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69144" y="2637524"/>
              <a:ext cx="1596573" cy="1062912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AB9E71F7-1D0D-6365-BA53-D0E506437A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519451" y="2637524"/>
              <a:ext cx="1596573" cy="1062912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656572B4-8884-EBD7-17E1-D464580A1D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07978" y="4550384"/>
              <a:ext cx="1557739" cy="1690726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9A957222-31B7-CD90-9D6B-60A6FC987A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519451" y="4576717"/>
              <a:ext cx="1775462" cy="163661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4736427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368E6D05-0246-FA7E-FF2A-DB5CEB460194}"/>
              </a:ext>
            </a:extLst>
          </p:cNvPr>
          <p:cNvGrpSpPr/>
          <p:nvPr/>
        </p:nvGrpSpPr>
        <p:grpSpPr>
          <a:xfrm>
            <a:off x="-81280" y="761953"/>
            <a:ext cx="10027920" cy="6003558"/>
            <a:chOff x="-81280" y="761953"/>
            <a:chExt cx="10027920" cy="6003558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5C9D3635-9618-3628-A35E-F517DC00C354}"/>
                </a:ext>
              </a:extLst>
            </p:cNvPr>
            <p:cNvSpPr txBox="1"/>
            <p:nvPr/>
          </p:nvSpPr>
          <p:spPr>
            <a:xfrm>
              <a:off x="123379" y="6396179"/>
              <a:ext cx="73697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 err="1"/>
                <a:t>sFigure</a:t>
              </a:r>
              <a:r>
                <a:rPr lang="en-US" altLang="zh-CN" b="1" dirty="0"/>
                <a:t> 2A Nfatc3 and Histone H3 (BMDMs)</a:t>
              </a:r>
              <a:endParaRPr lang="zh-CN" altLang="en-US" b="1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FE4CED71-7EB9-ECD3-5761-CB8685FAAD2F}"/>
                </a:ext>
              </a:extLst>
            </p:cNvPr>
            <p:cNvSpPr txBox="1"/>
            <p:nvPr/>
          </p:nvSpPr>
          <p:spPr>
            <a:xfrm>
              <a:off x="252848" y="1151472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E1B1CA4A-4D62-9322-6FBA-12A86A5AEBB5}"/>
                </a:ext>
              </a:extLst>
            </p:cNvPr>
            <p:cNvSpPr txBox="1"/>
            <p:nvPr/>
          </p:nvSpPr>
          <p:spPr>
            <a:xfrm>
              <a:off x="4852945" y="1151471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Histone H3 (15kD)</a:t>
              </a:r>
              <a:endParaRPr lang="zh-CN" altLang="en-US" sz="1600" dirty="0"/>
            </a:p>
          </p:txBody>
        </p: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EBAAE0CA-9B00-F2BB-F888-E76D82A5FACD}"/>
                </a:ext>
              </a:extLst>
            </p:cNvPr>
            <p:cNvCxnSpPr/>
            <p:nvPr/>
          </p:nvCxnSpPr>
          <p:spPr>
            <a:xfrm>
              <a:off x="-40640" y="2218690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A628F266-253C-3BE4-EA5E-1B193C607BBE}"/>
                </a:ext>
              </a:extLst>
            </p:cNvPr>
            <p:cNvCxnSpPr/>
            <p:nvPr/>
          </p:nvCxnSpPr>
          <p:spPr>
            <a:xfrm>
              <a:off x="-81280" y="4305062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3DC127EC-14C0-651F-2047-542C90EFCBDB}"/>
                </a:ext>
              </a:extLst>
            </p:cNvPr>
            <p:cNvSpPr txBox="1"/>
            <p:nvPr/>
          </p:nvSpPr>
          <p:spPr>
            <a:xfrm>
              <a:off x="252848" y="3016219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493B41DD-402D-F60B-2A00-ECB4CE977D1D}"/>
                </a:ext>
              </a:extLst>
            </p:cNvPr>
            <p:cNvSpPr txBox="1"/>
            <p:nvPr/>
          </p:nvSpPr>
          <p:spPr>
            <a:xfrm>
              <a:off x="4852945" y="3016218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Histone H3 (15kD)</a:t>
              </a:r>
              <a:endParaRPr lang="zh-CN" altLang="en-US" sz="1600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A79827B-38A5-DB5E-7036-5D83FD5191E4}"/>
                </a:ext>
              </a:extLst>
            </p:cNvPr>
            <p:cNvSpPr txBox="1"/>
            <p:nvPr/>
          </p:nvSpPr>
          <p:spPr>
            <a:xfrm>
              <a:off x="252848" y="5181344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D25B211-3346-A040-585C-1A3375455CB2}"/>
                </a:ext>
              </a:extLst>
            </p:cNvPr>
            <p:cNvSpPr txBox="1"/>
            <p:nvPr/>
          </p:nvSpPr>
          <p:spPr>
            <a:xfrm>
              <a:off x="4852945" y="5181343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Histone H3 (15kD)</a:t>
              </a:r>
              <a:endParaRPr lang="zh-CN" altLang="en-US" sz="1600" dirty="0"/>
            </a:p>
          </p:txBody>
        </p: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9F0CC3D7-0651-A98C-B003-34A2ADEB2E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89100" y="761953"/>
              <a:ext cx="2463013" cy="1117590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617D335D-7731-F62E-60E8-8BCFD57BD2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497388" y="761953"/>
              <a:ext cx="1866900" cy="1117590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4E8D2CA1-5460-8231-8B62-DB797B81FB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89100" y="2589600"/>
              <a:ext cx="1312674" cy="1339808"/>
            </a:xfrm>
            <a:prstGeom prst="rect">
              <a:avLst/>
            </a:prstGeom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606CA276-459B-8885-15AF-F07C8409F2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497388" y="2518488"/>
              <a:ext cx="1485900" cy="1300984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4C346261-38D7-1BA8-3C40-7E43EBE11A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89100" y="4618230"/>
              <a:ext cx="2578100" cy="1339808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E509C497-DDC0-E898-FE96-708C1BB6D5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497388" y="4503897"/>
              <a:ext cx="1549400" cy="187449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9238895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98E33D57-0E7B-F548-1F22-DAF3337B2980}"/>
              </a:ext>
            </a:extLst>
          </p:cNvPr>
          <p:cNvGrpSpPr/>
          <p:nvPr/>
        </p:nvGrpSpPr>
        <p:grpSpPr>
          <a:xfrm>
            <a:off x="-81280" y="555206"/>
            <a:ext cx="10027920" cy="6210305"/>
            <a:chOff x="-81280" y="555206"/>
            <a:chExt cx="10027920" cy="6210305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5C9D3635-9618-3628-A35E-F517DC00C354}"/>
                </a:ext>
              </a:extLst>
            </p:cNvPr>
            <p:cNvSpPr txBox="1"/>
            <p:nvPr/>
          </p:nvSpPr>
          <p:spPr>
            <a:xfrm>
              <a:off x="123379" y="6396179"/>
              <a:ext cx="73697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 err="1"/>
                <a:t>sFigure</a:t>
              </a:r>
              <a:r>
                <a:rPr lang="en-US" altLang="zh-CN" b="1" dirty="0"/>
                <a:t> 2B Nfatc3 and Histone H3 (RAW264.7 cells)</a:t>
              </a:r>
              <a:endParaRPr lang="zh-CN" altLang="en-US" b="1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FE4CED71-7EB9-ECD3-5761-CB8685FAAD2F}"/>
                </a:ext>
              </a:extLst>
            </p:cNvPr>
            <p:cNvSpPr txBox="1"/>
            <p:nvPr/>
          </p:nvSpPr>
          <p:spPr>
            <a:xfrm>
              <a:off x="252848" y="1151472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E1B1CA4A-4D62-9322-6FBA-12A86A5AEBB5}"/>
                </a:ext>
              </a:extLst>
            </p:cNvPr>
            <p:cNvSpPr txBox="1"/>
            <p:nvPr/>
          </p:nvSpPr>
          <p:spPr>
            <a:xfrm>
              <a:off x="4852945" y="1151471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Histone H3 (15kD)</a:t>
              </a:r>
              <a:endParaRPr lang="zh-CN" altLang="en-US" sz="1600" dirty="0"/>
            </a:p>
          </p:txBody>
        </p: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EBAAE0CA-9B00-F2BB-F888-E76D82A5FACD}"/>
                </a:ext>
              </a:extLst>
            </p:cNvPr>
            <p:cNvCxnSpPr/>
            <p:nvPr/>
          </p:nvCxnSpPr>
          <p:spPr>
            <a:xfrm>
              <a:off x="-40640" y="2218690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A628F266-253C-3BE4-EA5E-1B193C607BBE}"/>
                </a:ext>
              </a:extLst>
            </p:cNvPr>
            <p:cNvCxnSpPr/>
            <p:nvPr/>
          </p:nvCxnSpPr>
          <p:spPr>
            <a:xfrm>
              <a:off x="-81280" y="4305062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3DC127EC-14C0-651F-2047-542C90EFCBDB}"/>
                </a:ext>
              </a:extLst>
            </p:cNvPr>
            <p:cNvSpPr txBox="1"/>
            <p:nvPr/>
          </p:nvSpPr>
          <p:spPr>
            <a:xfrm>
              <a:off x="252848" y="3016219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493B41DD-402D-F60B-2A00-ECB4CE977D1D}"/>
                </a:ext>
              </a:extLst>
            </p:cNvPr>
            <p:cNvSpPr txBox="1"/>
            <p:nvPr/>
          </p:nvSpPr>
          <p:spPr>
            <a:xfrm>
              <a:off x="4852945" y="3016218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Histone H3 (15kD)</a:t>
              </a:r>
              <a:endParaRPr lang="zh-CN" altLang="en-US" sz="1600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A79827B-38A5-DB5E-7036-5D83FD5191E4}"/>
                </a:ext>
              </a:extLst>
            </p:cNvPr>
            <p:cNvSpPr txBox="1"/>
            <p:nvPr/>
          </p:nvSpPr>
          <p:spPr>
            <a:xfrm>
              <a:off x="252848" y="5181344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D25B211-3346-A040-585C-1A3375455CB2}"/>
                </a:ext>
              </a:extLst>
            </p:cNvPr>
            <p:cNvSpPr txBox="1"/>
            <p:nvPr/>
          </p:nvSpPr>
          <p:spPr>
            <a:xfrm>
              <a:off x="4852945" y="5181343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Histone H3 (15kD)</a:t>
              </a:r>
              <a:endParaRPr lang="zh-CN" altLang="en-US" sz="1600" dirty="0"/>
            </a:p>
          </p:txBody>
        </p: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B89E8845-14DD-6C42-D982-8113D0F340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67436" y="555206"/>
              <a:ext cx="2257662" cy="1577710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122EF62A-08A9-D0AA-B57A-D38D933C7F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503444" y="777551"/>
              <a:ext cx="1775461" cy="1186809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756EAED2-5AA1-6698-591A-D575323AEA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-1730"/>
            <a:stretch/>
          </p:blipFill>
          <p:spPr>
            <a:xfrm>
              <a:off x="1667436" y="2533425"/>
              <a:ext cx="2840491" cy="1401468"/>
            </a:xfrm>
            <a:prstGeom prst="rect">
              <a:avLst/>
            </a:prstGeom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02A35CB9-BD11-4ABA-2665-C5A1A8E22C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503444" y="2607450"/>
              <a:ext cx="3011817" cy="1253418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C3F18F00-0BC8-EAA1-263C-2A8C70037D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67436" y="4558111"/>
              <a:ext cx="2729752" cy="1585020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C6F04542-DF2C-13AD-4735-FA7C697D8C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503444" y="4509428"/>
              <a:ext cx="2729752" cy="186343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19496240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5FCD1C6B-AFBA-EDF5-5923-5A145728D8CE}"/>
              </a:ext>
            </a:extLst>
          </p:cNvPr>
          <p:cNvGrpSpPr/>
          <p:nvPr/>
        </p:nvGrpSpPr>
        <p:grpSpPr>
          <a:xfrm>
            <a:off x="-81280" y="590919"/>
            <a:ext cx="10027920" cy="6174592"/>
            <a:chOff x="-81280" y="590919"/>
            <a:chExt cx="10027920" cy="6174592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5C9D3635-9618-3628-A35E-F517DC00C354}"/>
                </a:ext>
              </a:extLst>
            </p:cNvPr>
            <p:cNvSpPr txBox="1"/>
            <p:nvPr/>
          </p:nvSpPr>
          <p:spPr>
            <a:xfrm>
              <a:off x="123379" y="6396179"/>
              <a:ext cx="73697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 err="1"/>
                <a:t>sFigure</a:t>
              </a:r>
              <a:r>
                <a:rPr lang="en-US" altLang="zh-CN" b="1" dirty="0"/>
                <a:t> 2B Nfatc3 and Histone H3 (BMDMs)</a:t>
              </a:r>
              <a:endParaRPr lang="zh-CN" altLang="en-US" b="1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FE4CED71-7EB9-ECD3-5761-CB8685FAAD2F}"/>
                </a:ext>
              </a:extLst>
            </p:cNvPr>
            <p:cNvSpPr txBox="1"/>
            <p:nvPr/>
          </p:nvSpPr>
          <p:spPr>
            <a:xfrm>
              <a:off x="252848" y="1151472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E1B1CA4A-4D62-9322-6FBA-12A86A5AEBB5}"/>
                </a:ext>
              </a:extLst>
            </p:cNvPr>
            <p:cNvSpPr txBox="1"/>
            <p:nvPr/>
          </p:nvSpPr>
          <p:spPr>
            <a:xfrm>
              <a:off x="4852945" y="1151471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Histone H3 (15kD)</a:t>
              </a:r>
              <a:endParaRPr lang="zh-CN" altLang="en-US" sz="1600" dirty="0"/>
            </a:p>
          </p:txBody>
        </p:sp>
        <p:cxnSp>
          <p:nvCxnSpPr>
            <p:cNvPr id="8" name="直接连接符 7">
              <a:extLst>
                <a:ext uri="{FF2B5EF4-FFF2-40B4-BE49-F238E27FC236}">
                  <a16:creationId xmlns:a16="http://schemas.microsoft.com/office/drawing/2014/main" id="{EBAAE0CA-9B00-F2BB-F888-E76D82A5FACD}"/>
                </a:ext>
              </a:extLst>
            </p:cNvPr>
            <p:cNvCxnSpPr/>
            <p:nvPr/>
          </p:nvCxnSpPr>
          <p:spPr>
            <a:xfrm>
              <a:off x="-40640" y="2218690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A628F266-253C-3BE4-EA5E-1B193C607BBE}"/>
                </a:ext>
              </a:extLst>
            </p:cNvPr>
            <p:cNvCxnSpPr/>
            <p:nvPr/>
          </p:nvCxnSpPr>
          <p:spPr>
            <a:xfrm>
              <a:off x="-81280" y="4305062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3DC127EC-14C0-651F-2047-542C90EFCBDB}"/>
                </a:ext>
              </a:extLst>
            </p:cNvPr>
            <p:cNvSpPr txBox="1"/>
            <p:nvPr/>
          </p:nvSpPr>
          <p:spPr>
            <a:xfrm>
              <a:off x="252848" y="3016219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493B41DD-402D-F60B-2A00-ECB4CE977D1D}"/>
                </a:ext>
              </a:extLst>
            </p:cNvPr>
            <p:cNvSpPr txBox="1"/>
            <p:nvPr/>
          </p:nvSpPr>
          <p:spPr>
            <a:xfrm>
              <a:off x="4852945" y="3016218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Histone H3 (15kD)</a:t>
              </a:r>
              <a:endParaRPr lang="zh-CN" altLang="en-US" sz="1600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A79827B-38A5-DB5E-7036-5D83FD5191E4}"/>
                </a:ext>
              </a:extLst>
            </p:cNvPr>
            <p:cNvSpPr txBox="1"/>
            <p:nvPr/>
          </p:nvSpPr>
          <p:spPr>
            <a:xfrm>
              <a:off x="252848" y="5181344"/>
              <a:ext cx="2463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Nfatc3 (130kD) </a:t>
              </a:r>
              <a:endParaRPr lang="zh-CN" altLang="en-US" sz="1600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D25B211-3346-A040-585C-1A3375455CB2}"/>
                </a:ext>
              </a:extLst>
            </p:cNvPr>
            <p:cNvSpPr txBox="1"/>
            <p:nvPr/>
          </p:nvSpPr>
          <p:spPr>
            <a:xfrm>
              <a:off x="4852945" y="5181343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Histone H3 (15kD)</a:t>
              </a:r>
              <a:endParaRPr lang="zh-CN" altLang="en-US" sz="1600" dirty="0"/>
            </a:p>
          </p:txBody>
        </p:sp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3D4D096F-4426-DEEA-DF2D-B8D0A83CE2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95450" y="783032"/>
              <a:ext cx="2781300" cy="1187629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2EB86FFC-7ED6-3058-6BB1-B858B19E6D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510792" y="590919"/>
              <a:ext cx="3209595" cy="1541067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05B18BB5-6150-FB56-B7A2-4C17D48242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95450" y="2565681"/>
              <a:ext cx="1775461" cy="1387646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78C4973B-87F2-32C6-3B3F-E13313BACC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510792" y="2573654"/>
              <a:ext cx="2138082" cy="1223681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6D2657E9-4DB5-F606-61A7-689F279DBD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89315" y="4679240"/>
              <a:ext cx="2053092" cy="1342761"/>
            </a:xfrm>
            <a:prstGeom prst="rect">
              <a:avLst/>
            </a:prstGeom>
          </p:spPr>
        </p:pic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AF7EFE9C-8338-8430-5C51-1827D9A1D5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510792" y="4535674"/>
              <a:ext cx="1498232" cy="173140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518508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F2744B8B-EE0B-8FE6-B009-3EB992B5E00B}"/>
              </a:ext>
            </a:extLst>
          </p:cNvPr>
          <p:cNvGrpSpPr/>
          <p:nvPr/>
        </p:nvGrpSpPr>
        <p:grpSpPr>
          <a:xfrm>
            <a:off x="123379" y="1103835"/>
            <a:ext cx="7518154" cy="5661676"/>
            <a:chOff x="123379" y="1103835"/>
            <a:chExt cx="7518154" cy="5661676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2C16024B-0A52-FB5B-B438-627A642A22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97064" y="2148337"/>
              <a:ext cx="2072645" cy="2177206"/>
            </a:xfrm>
            <a:prstGeom prst="rect">
              <a:avLst/>
            </a:prstGeom>
          </p:spPr>
        </p:pic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1247CDA8-4FD6-2B75-F679-65526339D149}"/>
                </a:ext>
              </a:extLst>
            </p:cNvPr>
            <p:cNvSpPr txBox="1"/>
            <p:nvPr/>
          </p:nvSpPr>
          <p:spPr>
            <a:xfrm>
              <a:off x="123379" y="6396179"/>
              <a:ext cx="216101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Figure 1G Pou3f1</a:t>
              </a:r>
              <a:endParaRPr lang="zh-CN" altLang="en-US" b="1" dirty="0"/>
            </a:p>
          </p:txBody>
        </p:sp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F612EA52-4796-2FF1-3A96-C8E1BDE3E1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7442" t="24512" r="26759" b="24717"/>
            <a:stretch/>
          </p:blipFill>
          <p:spPr>
            <a:xfrm>
              <a:off x="3790415" y="2255985"/>
              <a:ext cx="1866900" cy="2069558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ED9FE726-BCAF-785B-EBED-30962216F8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74632" y="2255985"/>
              <a:ext cx="1866901" cy="2069558"/>
            </a:xfrm>
            <a:prstGeom prst="rect">
              <a:avLst/>
            </a:prstGeom>
          </p:spPr>
        </p:pic>
        <p:grpSp>
          <p:nvGrpSpPr>
            <p:cNvPr id="14" name="组合 13">
              <a:extLst>
                <a:ext uri="{FF2B5EF4-FFF2-40B4-BE49-F238E27FC236}">
                  <a16:creationId xmlns:a16="http://schemas.microsoft.com/office/drawing/2014/main" id="{167BB720-C84F-68D0-246E-B0196B81906A}"/>
                </a:ext>
              </a:extLst>
            </p:cNvPr>
            <p:cNvGrpSpPr/>
            <p:nvPr/>
          </p:nvGrpSpPr>
          <p:grpSpPr>
            <a:xfrm>
              <a:off x="2104481" y="1103835"/>
              <a:ext cx="1622833" cy="1267809"/>
              <a:chOff x="2104481" y="1103835"/>
              <a:chExt cx="1622833" cy="1267809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7D97B78D-C7AF-08CC-3AD4-A9051DD6FAC6}"/>
                  </a:ext>
                </a:extLst>
              </p:cNvPr>
              <p:cNvSpPr txBox="1"/>
              <p:nvPr/>
            </p:nvSpPr>
            <p:spPr>
              <a:xfrm rot="16200000">
                <a:off x="1970851" y="1888820"/>
                <a:ext cx="627095" cy="338554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r>
                  <a:rPr lang="en-US" altLang="zh-CN" sz="1600" dirty="0"/>
                  <a:t>Input</a:t>
                </a:r>
                <a:endParaRPr lang="zh-CN" altLang="en-US" sz="1600" dirty="0"/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ACAD632B-BA45-7A64-F4AE-18B8CC8DFA12}"/>
                  </a:ext>
                </a:extLst>
              </p:cNvPr>
              <p:cNvSpPr txBox="1"/>
              <p:nvPr/>
            </p:nvSpPr>
            <p:spPr>
              <a:xfrm rot="16200000">
                <a:off x="2171359" y="1691804"/>
                <a:ext cx="1021125" cy="33855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1600" dirty="0"/>
                  <a:t>IP-Nfatc3</a:t>
                </a:r>
                <a:endParaRPr lang="zh-CN" altLang="en-US" sz="1600" dirty="0"/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DECC674C-AF31-745A-ACC9-7F49613002CA}"/>
                  </a:ext>
                </a:extLst>
              </p:cNvPr>
              <p:cNvSpPr txBox="1"/>
              <p:nvPr/>
            </p:nvSpPr>
            <p:spPr>
              <a:xfrm rot="16200000">
                <a:off x="2711112" y="1888820"/>
                <a:ext cx="627095" cy="338554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r>
                  <a:rPr lang="en-US" altLang="zh-CN" sz="1600" dirty="0"/>
                  <a:t>Input</a:t>
                </a:r>
                <a:endParaRPr lang="zh-CN" altLang="en-US" sz="1600" dirty="0"/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CED5463D-EAAF-6847-61A6-E04A22F9608D}"/>
                  </a:ext>
                </a:extLst>
              </p:cNvPr>
              <p:cNvSpPr txBox="1"/>
              <p:nvPr/>
            </p:nvSpPr>
            <p:spPr>
              <a:xfrm rot="16200000">
                <a:off x="2859538" y="1679858"/>
                <a:ext cx="1045019" cy="33855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1600" dirty="0"/>
                  <a:t>IP-Nfatc3</a:t>
                </a:r>
                <a:endParaRPr lang="zh-CN" altLang="en-US" sz="1600" dirty="0"/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B6FD2300-0F22-E372-863C-7606E8287D33}"/>
                  </a:ext>
                </a:extLst>
              </p:cNvPr>
              <p:cNvSpPr txBox="1"/>
              <p:nvPr/>
            </p:nvSpPr>
            <p:spPr>
              <a:xfrm>
                <a:off x="2104481" y="1103836"/>
                <a:ext cx="914463" cy="338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/>
                  <a:t>Control</a:t>
                </a: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9559D0D8-2B99-6AEF-B35F-13442F649767}"/>
                  </a:ext>
                </a:extLst>
              </p:cNvPr>
              <p:cNvSpPr txBox="1"/>
              <p:nvPr/>
            </p:nvSpPr>
            <p:spPr>
              <a:xfrm>
                <a:off x="2853268" y="1103835"/>
                <a:ext cx="87404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/>
                  <a:t>UC-CRC</a:t>
                </a:r>
                <a:endParaRPr lang="zh-CN" altLang="en-US" sz="1600" dirty="0"/>
              </a:p>
            </p:txBody>
          </p:sp>
          <p:cxnSp>
            <p:nvCxnSpPr>
              <p:cNvPr id="19" name="直接连接符 18">
                <a:extLst>
                  <a:ext uri="{FF2B5EF4-FFF2-40B4-BE49-F238E27FC236}">
                    <a16:creationId xmlns:a16="http://schemas.microsoft.com/office/drawing/2014/main" id="{27158B43-4F3B-02BC-145E-5143D899BDD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33599" y="1388047"/>
                <a:ext cx="49055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直接连接符 45">
                <a:extLst>
                  <a:ext uri="{FF2B5EF4-FFF2-40B4-BE49-F238E27FC236}">
                    <a16:creationId xmlns:a16="http://schemas.microsoft.com/office/drawing/2014/main" id="{94453FFC-E18C-9634-10A6-C16A1EFC81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73859" y="1388047"/>
                <a:ext cx="49055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8F82C90B-9FDC-FC46-7884-22F1564DF389}"/>
                </a:ext>
              </a:extLst>
            </p:cNvPr>
            <p:cNvGrpSpPr/>
            <p:nvPr/>
          </p:nvGrpSpPr>
          <p:grpSpPr>
            <a:xfrm>
              <a:off x="4029168" y="1110644"/>
              <a:ext cx="1508533" cy="1267809"/>
              <a:chOff x="2056856" y="1103835"/>
              <a:chExt cx="1508533" cy="1267809"/>
            </a:xfrm>
          </p:grpSpPr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49542AF7-1386-1CBB-BA03-7510879674B3}"/>
                  </a:ext>
                </a:extLst>
              </p:cNvPr>
              <p:cNvSpPr txBox="1"/>
              <p:nvPr/>
            </p:nvSpPr>
            <p:spPr>
              <a:xfrm rot="16200000">
                <a:off x="1970851" y="1888820"/>
                <a:ext cx="627095" cy="338554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r>
                  <a:rPr lang="en-US" altLang="zh-CN" sz="1600" dirty="0"/>
                  <a:t>Input</a:t>
                </a:r>
                <a:endParaRPr lang="zh-CN" altLang="en-US" sz="1600" dirty="0"/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52C092F3-A30F-6B7F-E7FC-A6AD864C8B2E}"/>
                  </a:ext>
                </a:extLst>
              </p:cNvPr>
              <p:cNvSpPr txBox="1"/>
              <p:nvPr/>
            </p:nvSpPr>
            <p:spPr>
              <a:xfrm rot="16200000">
                <a:off x="2076109" y="1691804"/>
                <a:ext cx="1021125" cy="33855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1600" dirty="0"/>
                  <a:t>IP-Nfatc3</a:t>
                </a:r>
                <a:endParaRPr lang="zh-CN" altLang="en-US" sz="1600" dirty="0"/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D1A56A18-DAFB-C15A-E1A3-6AEF2B03C9FC}"/>
                  </a:ext>
                </a:extLst>
              </p:cNvPr>
              <p:cNvSpPr txBox="1"/>
              <p:nvPr/>
            </p:nvSpPr>
            <p:spPr>
              <a:xfrm rot="16200000">
                <a:off x="2549187" y="1888820"/>
                <a:ext cx="627095" cy="338554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r>
                  <a:rPr lang="en-US" altLang="zh-CN" sz="1600" dirty="0"/>
                  <a:t>Input</a:t>
                </a:r>
                <a:endParaRPr lang="zh-CN" altLang="en-US" sz="1600" dirty="0"/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C6CD22D3-1654-14B9-5514-9DF0FC852AEA}"/>
                  </a:ext>
                </a:extLst>
              </p:cNvPr>
              <p:cNvSpPr txBox="1"/>
              <p:nvPr/>
            </p:nvSpPr>
            <p:spPr>
              <a:xfrm rot="16200000">
                <a:off x="2669038" y="1679858"/>
                <a:ext cx="1045019" cy="33855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1600" dirty="0"/>
                  <a:t>IP-Nfatc3</a:t>
                </a:r>
                <a:endParaRPr lang="zh-CN" altLang="en-US" sz="1600" dirty="0"/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1498683D-3919-6CB2-439D-6B92331B033D}"/>
                  </a:ext>
                </a:extLst>
              </p:cNvPr>
              <p:cNvSpPr txBox="1"/>
              <p:nvPr/>
            </p:nvSpPr>
            <p:spPr>
              <a:xfrm>
                <a:off x="2056856" y="1103836"/>
                <a:ext cx="914463" cy="338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/>
                  <a:t>Control</a:t>
                </a: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2F61DDD8-5DE7-38D3-934A-282FFD9DCBB8}"/>
                  </a:ext>
                </a:extLst>
              </p:cNvPr>
              <p:cNvSpPr txBox="1"/>
              <p:nvPr/>
            </p:nvSpPr>
            <p:spPr>
              <a:xfrm>
                <a:off x="2691343" y="1103835"/>
                <a:ext cx="87404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/>
                  <a:t>UC-CRC</a:t>
                </a:r>
                <a:endParaRPr lang="zh-CN" altLang="en-US" sz="1600" dirty="0"/>
              </a:p>
            </p:txBody>
          </p:sp>
          <p:cxnSp>
            <p:nvCxnSpPr>
              <p:cNvPr id="62" name="直接连接符 61">
                <a:extLst>
                  <a:ext uri="{FF2B5EF4-FFF2-40B4-BE49-F238E27FC236}">
                    <a16:creationId xmlns:a16="http://schemas.microsoft.com/office/drawing/2014/main" id="{719BCD4D-C86F-0D49-9042-57C75F1557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85974" y="1388047"/>
                <a:ext cx="49055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直接连接符 62">
                <a:extLst>
                  <a:ext uri="{FF2B5EF4-FFF2-40B4-BE49-F238E27FC236}">
                    <a16:creationId xmlns:a16="http://schemas.microsoft.com/office/drawing/2014/main" id="{417D9561-3B72-2C07-D221-419D2C2C7AF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11934" y="1388047"/>
                <a:ext cx="49055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组合 72">
              <a:extLst>
                <a:ext uri="{FF2B5EF4-FFF2-40B4-BE49-F238E27FC236}">
                  <a16:creationId xmlns:a16="http://schemas.microsoft.com/office/drawing/2014/main" id="{2A7F1ABF-BFBF-FC06-FF34-F4C98CA1C5C1}"/>
                </a:ext>
              </a:extLst>
            </p:cNvPr>
            <p:cNvGrpSpPr/>
            <p:nvPr/>
          </p:nvGrpSpPr>
          <p:grpSpPr>
            <a:xfrm>
              <a:off x="5989277" y="1119657"/>
              <a:ext cx="1508533" cy="1267809"/>
              <a:chOff x="2056856" y="1103835"/>
              <a:chExt cx="1508533" cy="1267809"/>
            </a:xfrm>
          </p:grpSpPr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8B4BE2A7-5E5C-4640-C289-6AEA0FD54A76}"/>
                  </a:ext>
                </a:extLst>
              </p:cNvPr>
              <p:cNvSpPr txBox="1"/>
              <p:nvPr/>
            </p:nvSpPr>
            <p:spPr>
              <a:xfrm rot="16200000">
                <a:off x="1970851" y="1888820"/>
                <a:ext cx="627095" cy="338554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r>
                  <a:rPr lang="en-US" altLang="zh-CN" sz="1600" dirty="0"/>
                  <a:t>Input</a:t>
                </a:r>
                <a:endParaRPr lang="zh-CN" altLang="en-US" sz="1600" dirty="0"/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85F93E4B-7E05-8C13-AFCE-0D21B4BA27D3}"/>
                  </a:ext>
                </a:extLst>
              </p:cNvPr>
              <p:cNvSpPr txBox="1"/>
              <p:nvPr/>
            </p:nvSpPr>
            <p:spPr>
              <a:xfrm rot="16200000">
                <a:off x="2076109" y="1691804"/>
                <a:ext cx="1021125" cy="33855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1600" dirty="0"/>
                  <a:t>IP-Nfatc3</a:t>
                </a:r>
                <a:endParaRPr lang="zh-CN" altLang="en-US" sz="1600" dirty="0"/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B1F357A7-272D-E5B8-E00C-95B0CA42E2DE}"/>
                  </a:ext>
                </a:extLst>
              </p:cNvPr>
              <p:cNvSpPr txBox="1"/>
              <p:nvPr/>
            </p:nvSpPr>
            <p:spPr>
              <a:xfrm rot="16200000">
                <a:off x="2549187" y="1888820"/>
                <a:ext cx="627095" cy="338554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r>
                  <a:rPr lang="en-US" altLang="zh-CN" sz="1600" dirty="0"/>
                  <a:t>Input</a:t>
                </a:r>
                <a:endParaRPr lang="zh-CN" altLang="en-US" sz="1600" dirty="0"/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49D389AE-FBA0-AEAE-7EC3-0F8D9EAAE3A1}"/>
                  </a:ext>
                </a:extLst>
              </p:cNvPr>
              <p:cNvSpPr txBox="1"/>
              <p:nvPr/>
            </p:nvSpPr>
            <p:spPr>
              <a:xfrm rot="16200000">
                <a:off x="2669038" y="1679858"/>
                <a:ext cx="1045019" cy="33855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1600" dirty="0"/>
                  <a:t>IP-Nfatc3</a:t>
                </a:r>
                <a:endParaRPr lang="zh-CN" altLang="en-US" sz="1600" dirty="0"/>
              </a:p>
            </p:txBody>
          </p: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9B7062DE-81DC-39D7-D00F-8E718F0F22D7}"/>
                  </a:ext>
                </a:extLst>
              </p:cNvPr>
              <p:cNvSpPr txBox="1"/>
              <p:nvPr/>
            </p:nvSpPr>
            <p:spPr>
              <a:xfrm>
                <a:off x="2056856" y="1103836"/>
                <a:ext cx="914463" cy="338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/>
                  <a:t>Control</a:t>
                </a:r>
              </a:p>
            </p:txBody>
          </p:sp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8DCA352D-AD75-C26B-F06C-E93A0BC1E397}"/>
                  </a:ext>
                </a:extLst>
              </p:cNvPr>
              <p:cNvSpPr txBox="1"/>
              <p:nvPr/>
            </p:nvSpPr>
            <p:spPr>
              <a:xfrm>
                <a:off x="2691343" y="1103835"/>
                <a:ext cx="87404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/>
                  <a:t>UC-CRC</a:t>
                </a:r>
                <a:endParaRPr lang="zh-CN" altLang="en-US" sz="1600" dirty="0"/>
              </a:p>
            </p:txBody>
          </p:sp>
          <p:cxnSp>
            <p:nvCxnSpPr>
              <p:cNvPr id="80" name="直接连接符 79">
                <a:extLst>
                  <a:ext uri="{FF2B5EF4-FFF2-40B4-BE49-F238E27FC236}">
                    <a16:creationId xmlns:a16="http://schemas.microsoft.com/office/drawing/2014/main" id="{4DF0AEC8-95E9-A8E9-900E-7F1AF9CD22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85974" y="1388047"/>
                <a:ext cx="49055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直接连接符 80">
                <a:extLst>
                  <a:ext uri="{FF2B5EF4-FFF2-40B4-BE49-F238E27FC236}">
                    <a16:creationId xmlns:a16="http://schemas.microsoft.com/office/drawing/2014/main" id="{285CFDEE-BAD7-84BA-8759-70A2E0F2135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11934" y="1388047"/>
                <a:ext cx="49055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94894603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01A6FC95-1A08-1358-3E65-4DDC607607FD}"/>
              </a:ext>
            </a:extLst>
          </p:cNvPr>
          <p:cNvGrpSpPr/>
          <p:nvPr/>
        </p:nvGrpSpPr>
        <p:grpSpPr>
          <a:xfrm>
            <a:off x="-81280" y="0"/>
            <a:ext cx="9987280" cy="6765511"/>
            <a:chOff x="-81280" y="0"/>
            <a:chExt cx="9987280" cy="6765511"/>
          </a:xfrm>
        </p:grpSpPr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ED3B45D4-CFBD-4F8F-BD66-F4FC881CBD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76192" y="625373"/>
              <a:ext cx="1235270" cy="1054098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AD2E5592-5AE7-4400-8024-D67B401EA1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71982" y="687136"/>
              <a:ext cx="2679635" cy="930571"/>
            </a:xfrm>
            <a:prstGeom prst="rect">
              <a:avLst/>
            </a:prstGeom>
          </p:spPr>
        </p:pic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3559CD5D-3C8A-477A-AEDF-3DEFF797B593}"/>
                </a:ext>
              </a:extLst>
            </p:cNvPr>
            <p:cNvCxnSpPr/>
            <p:nvPr/>
          </p:nvCxnSpPr>
          <p:spPr>
            <a:xfrm>
              <a:off x="-81280" y="2089134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56538D12-0F8C-F574-43E1-D51F94FD1ABE}"/>
                </a:ext>
              </a:extLst>
            </p:cNvPr>
            <p:cNvSpPr txBox="1"/>
            <p:nvPr/>
          </p:nvSpPr>
          <p:spPr>
            <a:xfrm>
              <a:off x="123379" y="6396179"/>
              <a:ext cx="487026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 err="1"/>
                <a:t>sFigure</a:t>
              </a:r>
              <a:r>
                <a:rPr lang="en-US" altLang="zh-CN" b="1" dirty="0"/>
                <a:t> 3B Pou3f1 and GAPDH (RAW264.7 cells)</a:t>
              </a:r>
              <a:endParaRPr lang="zh-CN" altLang="en-US" b="1" dirty="0"/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D509087D-667A-335C-7CEA-D507F4F809D5}"/>
                </a:ext>
              </a:extLst>
            </p:cNvPr>
            <p:cNvSpPr txBox="1"/>
            <p:nvPr/>
          </p:nvSpPr>
          <p:spPr>
            <a:xfrm>
              <a:off x="232430" y="983145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78CE8E15-BDD9-7BED-5D1C-E9E24291D131}"/>
                </a:ext>
              </a:extLst>
            </p:cNvPr>
            <p:cNvSpPr txBox="1"/>
            <p:nvPr/>
          </p:nvSpPr>
          <p:spPr>
            <a:xfrm>
              <a:off x="4993640" y="983145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1B5D49F2-86E1-2BF2-501C-8CE6AE3587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76192" y="2549643"/>
              <a:ext cx="2307039" cy="1067317"/>
            </a:xfrm>
            <a:prstGeom prst="rect">
              <a:avLst/>
            </a:prstGeom>
          </p:spPr>
        </p:pic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7941188E-ADAA-5744-662F-FEA3F78E54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71982" y="2356025"/>
              <a:ext cx="1702938" cy="1443164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689CD14D-F0ED-D029-3490-527B4F0600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76192" y="4503102"/>
              <a:ext cx="1630146" cy="1193271"/>
            </a:xfrm>
            <a:prstGeom prst="rect">
              <a:avLst/>
            </a:prstGeom>
          </p:spPr>
        </p:pic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2E50A6A0-2FB4-4BDF-766A-BAB373EED5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71982" y="4499460"/>
              <a:ext cx="2670030" cy="1163687"/>
            </a:xfrm>
            <a:prstGeom prst="rect">
              <a:avLst/>
            </a:prstGeom>
          </p:spPr>
        </p:pic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931C4710-00C9-18BC-C404-57EAB1E03D66}"/>
                </a:ext>
              </a:extLst>
            </p:cNvPr>
            <p:cNvSpPr txBox="1"/>
            <p:nvPr/>
          </p:nvSpPr>
          <p:spPr>
            <a:xfrm>
              <a:off x="232430" y="2935233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9F1ADC23-0537-EEFD-A780-306F77E55EEC}"/>
                </a:ext>
              </a:extLst>
            </p:cNvPr>
            <p:cNvSpPr txBox="1"/>
            <p:nvPr/>
          </p:nvSpPr>
          <p:spPr>
            <a:xfrm>
              <a:off x="4993640" y="2935233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5EF8B585-5A05-6163-0F02-0B61AA753CC1}"/>
                </a:ext>
              </a:extLst>
            </p:cNvPr>
            <p:cNvSpPr txBox="1"/>
            <p:nvPr/>
          </p:nvSpPr>
          <p:spPr>
            <a:xfrm>
              <a:off x="232430" y="4915690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E8D92042-419E-BF3A-2185-B687AFCF62F7}"/>
                </a:ext>
              </a:extLst>
            </p:cNvPr>
            <p:cNvSpPr txBox="1"/>
            <p:nvPr/>
          </p:nvSpPr>
          <p:spPr>
            <a:xfrm>
              <a:off x="4993640" y="4915690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16CC58A9-2C93-6595-96FF-3669D5887664}"/>
                </a:ext>
              </a:extLst>
            </p:cNvPr>
            <p:cNvCxnSpPr/>
            <p:nvPr/>
          </p:nvCxnSpPr>
          <p:spPr>
            <a:xfrm>
              <a:off x="-81280" y="4141586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9D692468-2C8D-B6F7-8104-C0AD788B2E6F}"/>
                </a:ext>
              </a:extLst>
            </p:cNvPr>
            <p:cNvSpPr txBox="1"/>
            <p:nvPr/>
          </p:nvSpPr>
          <p:spPr>
            <a:xfrm>
              <a:off x="114300" y="0"/>
              <a:ext cx="372922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800" b="1" dirty="0">
                  <a:solidFill>
                    <a:srgbClr val="0000FF"/>
                  </a:solidFill>
                </a:rPr>
                <a:t>Supplementary Figure 3</a:t>
              </a:r>
              <a:endParaRPr lang="zh-CN" altLang="en-US" sz="2800" b="1" dirty="0">
                <a:solidFill>
                  <a:srgbClr val="0000FF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558909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5E9C3D3A-4B78-124B-EF2E-F02EFCCDE53D}"/>
              </a:ext>
            </a:extLst>
          </p:cNvPr>
          <p:cNvGrpSpPr/>
          <p:nvPr/>
        </p:nvGrpSpPr>
        <p:grpSpPr>
          <a:xfrm>
            <a:off x="114300" y="0"/>
            <a:ext cx="8194604" cy="6765511"/>
            <a:chOff x="114300" y="0"/>
            <a:chExt cx="8194604" cy="6765511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E47695B4-C073-4750-87AC-197B5A179B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09986" y="2079004"/>
              <a:ext cx="2118359" cy="2202180"/>
            </a:xfrm>
            <a:prstGeom prst="rect">
              <a:avLst/>
            </a:prstGeom>
          </p:spPr>
        </p:pic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9B10B5EE-6EEB-59E1-64C1-EE42A25891C2}"/>
                </a:ext>
              </a:extLst>
            </p:cNvPr>
            <p:cNvGrpSpPr/>
            <p:nvPr/>
          </p:nvGrpSpPr>
          <p:grpSpPr>
            <a:xfrm>
              <a:off x="2202142" y="1203936"/>
              <a:ext cx="1478211" cy="948849"/>
              <a:chOff x="2480977" y="1372664"/>
              <a:chExt cx="1478211" cy="948849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6611B03E-8AA4-4A7E-9DC4-723B1254BA1F}"/>
                  </a:ext>
                </a:extLst>
              </p:cNvPr>
              <p:cNvSpPr txBox="1"/>
              <p:nvPr/>
            </p:nvSpPr>
            <p:spPr>
              <a:xfrm rot="16200000">
                <a:off x="2301440" y="1774633"/>
                <a:ext cx="69762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Water</a:t>
                </a:r>
                <a:endParaRPr lang="zh-CN" altLang="en-US" sz="1600" dirty="0"/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74909BD9-C84E-4941-A3CD-43CF5FAFDBF7}"/>
                  </a:ext>
                </a:extLst>
              </p:cNvPr>
              <p:cNvSpPr txBox="1"/>
              <p:nvPr/>
            </p:nvSpPr>
            <p:spPr>
              <a:xfrm rot="16200000">
                <a:off x="2733329" y="1797460"/>
                <a:ext cx="62709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Input</a:t>
                </a:r>
                <a:endParaRPr lang="zh-CN" altLang="en-US" sz="1600" dirty="0"/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0DCD6289-B0B4-42C9-B76F-C4B1EE148593}"/>
                  </a:ext>
                </a:extLst>
              </p:cNvPr>
              <p:cNvSpPr txBox="1"/>
              <p:nvPr/>
            </p:nvSpPr>
            <p:spPr>
              <a:xfrm rot="16200000">
                <a:off x="3052488" y="1778224"/>
                <a:ext cx="68159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IP-IgG</a:t>
                </a:r>
                <a:endParaRPr lang="zh-CN" altLang="en-US" sz="1600" dirty="0"/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E6579708-8692-40EE-81A4-FD813C537FFC}"/>
                  </a:ext>
                </a:extLst>
              </p:cNvPr>
              <p:cNvSpPr txBox="1"/>
              <p:nvPr/>
            </p:nvSpPr>
            <p:spPr>
              <a:xfrm rot="16200000">
                <a:off x="3315486" y="1677812"/>
                <a:ext cx="94884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IP-Nfatc3</a:t>
                </a:r>
                <a:endParaRPr lang="zh-CN" altLang="en-US" sz="1600" dirty="0"/>
              </a:p>
            </p:txBody>
          </p:sp>
        </p:grp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4FCF056-B4F4-42DC-9D41-33D07FB1D60A}"/>
                </a:ext>
              </a:extLst>
            </p:cNvPr>
            <p:cNvSpPr txBox="1"/>
            <p:nvPr/>
          </p:nvSpPr>
          <p:spPr>
            <a:xfrm>
              <a:off x="114300" y="0"/>
              <a:ext cx="137005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800" b="1" dirty="0">
                  <a:solidFill>
                    <a:srgbClr val="0000FF"/>
                  </a:solidFill>
                </a:rPr>
                <a:t>Figure 2</a:t>
              </a:r>
              <a:endParaRPr lang="zh-CN" altLang="en-US" sz="2800" b="1" dirty="0">
                <a:solidFill>
                  <a:srgbClr val="0000FF"/>
                </a:solidFill>
              </a:endParaRPr>
            </a:p>
          </p:txBody>
        </p:sp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498E159F-B2E7-A655-BFE7-DBA5F3ADAF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95985" y="2083823"/>
              <a:ext cx="2118359" cy="2202180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B30D82C4-C518-2D9A-11A8-A0C23D985F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81984" y="2025315"/>
              <a:ext cx="2026920" cy="2527817"/>
            </a:xfrm>
            <a:prstGeom prst="rect">
              <a:avLst/>
            </a:prstGeom>
          </p:spPr>
        </p:pic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BB956333-4BC8-B3D7-374A-39ABE7B5CBDD}"/>
                </a:ext>
              </a:extLst>
            </p:cNvPr>
            <p:cNvGrpSpPr/>
            <p:nvPr/>
          </p:nvGrpSpPr>
          <p:grpSpPr>
            <a:xfrm>
              <a:off x="4379473" y="1216619"/>
              <a:ext cx="1359461" cy="948849"/>
              <a:chOff x="2480977" y="1372664"/>
              <a:chExt cx="1359461" cy="948849"/>
            </a:xfrm>
          </p:grpSpPr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CC311723-9F07-9DF2-B989-887F014E41CF}"/>
                  </a:ext>
                </a:extLst>
              </p:cNvPr>
              <p:cNvSpPr txBox="1"/>
              <p:nvPr/>
            </p:nvSpPr>
            <p:spPr>
              <a:xfrm rot="16200000">
                <a:off x="2301440" y="1774633"/>
                <a:ext cx="69762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Water</a:t>
                </a:r>
                <a:endParaRPr lang="zh-CN" altLang="en-US" sz="1600" dirty="0"/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D9CA1125-99E7-8133-268A-903D3093CFF3}"/>
                  </a:ext>
                </a:extLst>
              </p:cNvPr>
              <p:cNvSpPr txBox="1"/>
              <p:nvPr/>
            </p:nvSpPr>
            <p:spPr>
              <a:xfrm rot="16200000">
                <a:off x="2673954" y="1797460"/>
                <a:ext cx="62709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Input</a:t>
                </a:r>
                <a:endParaRPr lang="zh-CN" altLang="en-US" sz="1600" dirty="0"/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F29DF862-FD05-2B2A-5010-AFEB04394946}"/>
                  </a:ext>
                </a:extLst>
              </p:cNvPr>
              <p:cNvSpPr txBox="1"/>
              <p:nvPr/>
            </p:nvSpPr>
            <p:spPr>
              <a:xfrm rot="16200000">
                <a:off x="3004988" y="1778224"/>
                <a:ext cx="68159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IP-IgG</a:t>
                </a:r>
                <a:endParaRPr lang="zh-CN" altLang="en-US" sz="1600" dirty="0"/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3F07D70F-2B71-C9AE-A245-DAC3A64C4F94}"/>
                  </a:ext>
                </a:extLst>
              </p:cNvPr>
              <p:cNvSpPr txBox="1"/>
              <p:nvPr/>
            </p:nvSpPr>
            <p:spPr>
              <a:xfrm rot="16200000">
                <a:off x="3196736" y="1677812"/>
                <a:ext cx="94884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IP-Nfatc3</a:t>
                </a:r>
                <a:endParaRPr lang="zh-CN" altLang="en-US" sz="1600" dirty="0"/>
              </a:p>
            </p:txBody>
          </p:sp>
        </p:grpSp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C4D44F1B-E307-7ABC-2CDE-73BC93F133F2}"/>
                </a:ext>
              </a:extLst>
            </p:cNvPr>
            <p:cNvGrpSpPr/>
            <p:nvPr/>
          </p:nvGrpSpPr>
          <p:grpSpPr>
            <a:xfrm>
              <a:off x="6657396" y="1216619"/>
              <a:ext cx="1181330" cy="948849"/>
              <a:chOff x="2480977" y="1372664"/>
              <a:chExt cx="1181330" cy="948849"/>
            </a:xfrm>
          </p:grpSpPr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FFC0D493-E5FE-67E0-7C71-3D121B31A37B}"/>
                  </a:ext>
                </a:extLst>
              </p:cNvPr>
              <p:cNvSpPr txBox="1"/>
              <p:nvPr/>
            </p:nvSpPr>
            <p:spPr>
              <a:xfrm rot="16200000">
                <a:off x="2301440" y="1774633"/>
                <a:ext cx="69762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Water</a:t>
                </a:r>
                <a:endParaRPr lang="zh-CN" altLang="en-US" sz="1600" dirty="0"/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DB4BB251-F9A0-C16B-0CA4-EE08116CF904}"/>
                  </a:ext>
                </a:extLst>
              </p:cNvPr>
              <p:cNvSpPr txBox="1"/>
              <p:nvPr/>
            </p:nvSpPr>
            <p:spPr>
              <a:xfrm rot="16200000">
                <a:off x="2614579" y="1797460"/>
                <a:ext cx="62709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Input</a:t>
                </a:r>
                <a:endParaRPr lang="zh-CN" altLang="en-US" sz="1600" dirty="0"/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A51F884A-41AC-8DE9-8731-0072F2F8790F}"/>
                  </a:ext>
                </a:extLst>
              </p:cNvPr>
              <p:cNvSpPr txBox="1"/>
              <p:nvPr/>
            </p:nvSpPr>
            <p:spPr>
              <a:xfrm rot="16200000">
                <a:off x="2886236" y="1778224"/>
                <a:ext cx="68159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IP-IgG</a:t>
                </a:r>
                <a:endParaRPr lang="zh-CN" altLang="en-US" sz="1600" dirty="0"/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CA66729D-77E4-B062-909C-81475EDF2D1A}"/>
                  </a:ext>
                </a:extLst>
              </p:cNvPr>
              <p:cNvSpPr txBox="1"/>
              <p:nvPr/>
            </p:nvSpPr>
            <p:spPr>
              <a:xfrm rot="16200000">
                <a:off x="3018605" y="1677812"/>
                <a:ext cx="94884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/>
                  <a:t>IP-Nfatc3</a:t>
                </a:r>
                <a:endParaRPr lang="zh-CN" altLang="en-US" sz="1600" dirty="0"/>
              </a:p>
            </p:txBody>
          </p:sp>
        </p:grp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D453F640-4984-0D3D-F204-BC7C3C610D4E}"/>
                </a:ext>
              </a:extLst>
            </p:cNvPr>
            <p:cNvSpPr txBox="1"/>
            <p:nvPr/>
          </p:nvSpPr>
          <p:spPr>
            <a:xfrm>
              <a:off x="123379" y="6396179"/>
              <a:ext cx="2161019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Figure 2B Pou3f1</a:t>
              </a:r>
              <a:endParaRPr lang="zh-CN" alt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1571562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A4E92380-69E5-4F5B-C4EE-69AD6B5C73B9}"/>
              </a:ext>
            </a:extLst>
          </p:cNvPr>
          <p:cNvGrpSpPr/>
          <p:nvPr/>
        </p:nvGrpSpPr>
        <p:grpSpPr>
          <a:xfrm>
            <a:off x="0" y="817058"/>
            <a:ext cx="9987280" cy="5948453"/>
            <a:chOff x="0" y="817058"/>
            <a:chExt cx="9987280" cy="5948453"/>
          </a:xfrm>
        </p:grpSpPr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644CABB-CAE9-4868-A54B-62347687885F}"/>
                </a:ext>
              </a:extLst>
            </p:cNvPr>
            <p:cNvSpPr txBox="1"/>
            <p:nvPr/>
          </p:nvSpPr>
          <p:spPr>
            <a:xfrm>
              <a:off x="369276" y="1118837"/>
              <a:ext cx="16974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F53FFD0-EB1A-49D9-B950-A0FA58DB1700}"/>
                </a:ext>
              </a:extLst>
            </p:cNvPr>
            <p:cNvSpPr txBox="1"/>
            <p:nvPr/>
          </p:nvSpPr>
          <p:spPr>
            <a:xfrm>
              <a:off x="4001769" y="1114947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4D108C14-EA61-4835-973D-FFC019726D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11842" y="817058"/>
              <a:ext cx="1400872" cy="1097513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7DE36313-1D84-4ACA-8315-608284FB0D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29033" y="846301"/>
              <a:ext cx="2923479" cy="980962"/>
            </a:xfrm>
            <a:prstGeom prst="rect">
              <a:avLst/>
            </a:prstGeom>
          </p:spPr>
        </p:pic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2472C3D6-DF7E-4138-AC95-96CA49BB4208}"/>
                </a:ext>
              </a:extLst>
            </p:cNvPr>
            <p:cNvCxnSpPr/>
            <p:nvPr/>
          </p:nvCxnSpPr>
          <p:spPr>
            <a:xfrm>
              <a:off x="0" y="2288540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1FA60E7C-CB5F-3E8D-CCBE-9BF4886FFD5C}"/>
                </a:ext>
              </a:extLst>
            </p:cNvPr>
            <p:cNvSpPr txBox="1"/>
            <p:nvPr/>
          </p:nvSpPr>
          <p:spPr>
            <a:xfrm>
              <a:off x="123379" y="6396179"/>
              <a:ext cx="482962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Figure 2G Pou3f1 and GAPDH (RAW264.7 cells)</a:t>
              </a:r>
              <a:endParaRPr lang="zh-CN" altLang="en-US" b="1" dirty="0"/>
            </a:p>
          </p:txBody>
        </p: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EA782847-8CC0-9971-9100-01E4D39366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30048" y="2613906"/>
              <a:ext cx="2146044" cy="1105028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E644E0D9-E503-E1D3-7C6E-1844E032ED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29033" y="2613906"/>
              <a:ext cx="2768652" cy="1081944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86462323-C407-994D-3CC9-2800672C9F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11842" y="4428404"/>
              <a:ext cx="2298700" cy="1229315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B35B1035-E1E0-4D7F-FFBF-3D3805A806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29033" y="4361084"/>
              <a:ext cx="1842771" cy="1292125"/>
            </a:xfrm>
            <a:prstGeom prst="rect">
              <a:avLst/>
            </a:prstGeom>
          </p:spPr>
        </p:pic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E4F5D682-0644-CB13-CFF4-245A8F535A23}"/>
                </a:ext>
              </a:extLst>
            </p:cNvPr>
            <p:cNvSpPr txBox="1"/>
            <p:nvPr/>
          </p:nvSpPr>
          <p:spPr>
            <a:xfrm>
              <a:off x="369276" y="3125801"/>
              <a:ext cx="16974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0B7E5E09-367D-A095-7F2F-1D25A005D152}"/>
                </a:ext>
              </a:extLst>
            </p:cNvPr>
            <p:cNvSpPr txBox="1"/>
            <p:nvPr/>
          </p:nvSpPr>
          <p:spPr>
            <a:xfrm>
              <a:off x="4001769" y="3121911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B69DDD24-0BD8-F2F1-2585-8A1EAAA47F48}"/>
                </a:ext>
              </a:extLst>
            </p:cNvPr>
            <p:cNvSpPr txBox="1"/>
            <p:nvPr/>
          </p:nvSpPr>
          <p:spPr>
            <a:xfrm>
              <a:off x="369276" y="5005424"/>
              <a:ext cx="169744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C249DE09-A67E-F907-2725-147627276624}"/>
                </a:ext>
              </a:extLst>
            </p:cNvPr>
            <p:cNvSpPr txBox="1"/>
            <p:nvPr/>
          </p:nvSpPr>
          <p:spPr>
            <a:xfrm>
              <a:off x="4001769" y="5001534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81669989-9A09-2372-A3D1-E72D3AD2DAB3}"/>
                </a:ext>
              </a:extLst>
            </p:cNvPr>
            <p:cNvCxnSpPr/>
            <p:nvPr/>
          </p:nvCxnSpPr>
          <p:spPr>
            <a:xfrm>
              <a:off x="0" y="4091940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49553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4A0D8D2E-0356-8840-CDE0-970C3506F3D9}"/>
              </a:ext>
            </a:extLst>
          </p:cNvPr>
          <p:cNvGrpSpPr/>
          <p:nvPr/>
        </p:nvGrpSpPr>
        <p:grpSpPr>
          <a:xfrm>
            <a:off x="-81280" y="503482"/>
            <a:ext cx="10068560" cy="6262029"/>
            <a:chOff x="-81280" y="503482"/>
            <a:chExt cx="10068560" cy="6262029"/>
          </a:xfrm>
        </p:grpSpPr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C440F997-B1A6-417A-BBCC-0C6D914087EC}"/>
                </a:ext>
              </a:extLst>
            </p:cNvPr>
            <p:cNvSpPr txBox="1"/>
            <p:nvPr/>
          </p:nvSpPr>
          <p:spPr>
            <a:xfrm>
              <a:off x="232430" y="983145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51EAAF68-BC0C-45BD-9366-EEE9CA08F4EF}"/>
                </a:ext>
              </a:extLst>
            </p:cNvPr>
            <p:cNvSpPr txBox="1"/>
            <p:nvPr/>
          </p:nvSpPr>
          <p:spPr>
            <a:xfrm>
              <a:off x="4993640" y="983145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C737FD86-3AAC-40DB-B6A1-5954AE6C8D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92861" y="699375"/>
              <a:ext cx="3062677" cy="947963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B3C10E6E-6021-447B-8DB4-9EFE1EE553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58789" y="503482"/>
              <a:ext cx="1370760" cy="1297879"/>
            </a:xfrm>
            <a:prstGeom prst="rect">
              <a:avLst/>
            </a:prstGeom>
          </p:spPr>
        </p:pic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2472C3D6-DF7E-4138-AC95-96CA49BB4208}"/>
                </a:ext>
              </a:extLst>
            </p:cNvPr>
            <p:cNvCxnSpPr/>
            <p:nvPr/>
          </p:nvCxnSpPr>
          <p:spPr>
            <a:xfrm>
              <a:off x="-81280" y="2034540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1FA60E7C-CB5F-3E8D-CCBE-9BF4886FFD5C}"/>
                </a:ext>
              </a:extLst>
            </p:cNvPr>
            <p:cNvSpPr txBox="1"/>
            <p:nvPr/>
          </p:nvSpPr>
          <p:spPr>
            <a:xfrm>
              <a:off x="123379" y="6396179"/>
              <a:ext cx="437242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Figure 2G Pou3f1 and GAPDH (BMDMs)</a:t>
              </a:r>
              <a:endParaRPr lang="zh-CN" altLang="en-US" b="1" dirty="0"/>
            </a:p>
          </p:txBody>
        </p: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55294C4B-461B-2873-E2E6-63FD815FCB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92861" y="2406355"/>
              <a:ext cx="1953500" cy="1085170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599BC9C0-103C-BA27-B393-8E973802B8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92861" y="4237271"/>
              <a:ext cx="2133600" cy="1412526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81C0AF49-EB99-840F-98D1-20E8BA0FA5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58789" y="2304134"/>
              <a:ext cx="1694969" cy="1297879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8665092D-A456-89F6-3258-C604D75B9E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58789" y="4368598"/>
              <a:ext cx="2438251" cy="1070034"/>
            </a:xfrm>
            <a:prstGeom prst="rect">
              <a:avLst/>
            </a:prstGeom>
          </p:spPr>
        </p:pic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64549F9-E13F-8054-F65A-43902581F84D}"/>
                </a:ext>
              </a:extLst>
            </p:cNvPr>
            <p:cNvSpPr txBox="1"/>
            <p:nvPr/>
          </p:nvSpPr>
          <p:spPr>
            <a:xfrm>
              <a:off x="232430" y="2798346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BD6EF97E-2DB6-E0C3-BB92-17530D0CB418}"/>
                </a:ext>
              </a:extLst>
            </p:cNvPr>
            <p:cNvSpPr txBox="1"/>
            <p:nvPr/>
          </p:nvSpPr>
          <p:spPr>
            <a:xfrm>
              <a:off x="4993640" y="2798346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AB3A93D6-EB37-A1FA-5D5F-CAF342E06516}"/>
                </a:ext>
              </a:extLst>
            </p:cNvPr>
            <p:cNvSpPr txBox="1"/>
            <p:nvPr/>
          </p:nvSpPr>
          <p:spPr>
            <a:xfrm>
              <a:off x="232430" y="4741905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65EA8474-A26C-9DB9-DEA0-BA4ED1056D36}"/>
                </a:ext>
              </a:extLst>
            </p:cNvPr>
            <p:cNvSpPr txBox="1"/>
            <p:nvPr/>
          </p:nvSpPr>
          <p:spPr>
            <a:xfrm>
              <a:off x="4993640" y="4741905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9CED9CA8-1EBA-84C4-B3BB-D55DD3515A42}"/>
                </a:ext>
              </a:extLst>
            </p:cNvPr>
            <p:cNvCxnSpPr/>
            <p:nvPr/>
          </p:nvCxnSpPr>
          <p:spPr>
            <a:xfrm>
              <a:off x="0" y="3939540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858180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449C6E14-3925-019C-FDF7-26441E45F1E8}"/>
              </a:ext>
            </a:extLst>
          </p:cNvPr>
          <p:cNvGrpSpPr/>
          <p:nvPr/>
        </p:nvGrpSpPr>
        <p:grpSpPr>
          <a:xfrm>
            <a:off x="0" y="0"/>
            <a:ext cx="10014496" cy="6765511"/>
            <a:chOff x="0" y="0"/>
            <a:chExt cx="10014496" cy="6765511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2412E512-7804-4A32-915B-58B9BE89C6DF}"/>
                </a:ext>
              </a:extLst>
            </p:cNvPr>
            <p:cNvSpPr txBox="1"/>
            <p:nvPr/>
          </p:nvSpPr>
          <p:spPr>
            <a:xfrm>
              <a:off x="114300" y="0"/>
              <a:ext cx="137005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800" b="1" dirty="0">
                  <a:solidFill>
                    <a:srgbClr val="0000FF"/>
                  </a:solidFill>
                </a:rPr>
                <a:t>Figure 3</a:t>
              </a:r>
              <a:endParaRPr lang="zh-CN" altLang="en-US" sz="2800" b="1" dirty="0">
                <a:solidFill>
                  <a:srgbClr val="0000FF"/>
                </a:solidFill>
              </a:endParaRPr>
            </a:p>
          </p:txBody>
        </p:sp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CE2692F9-9A7A-44AC-AD3F-DBCEE5DA4B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85264" y="750688"/>
              <a:ext cx="3055719" cy="929061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60EEDE52-0237-47B0-8456-8ADABF8E79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81017" y="799076"/>
              <a:ext cx="2593601" cy="784394"/>
            </a:xfrm>
            <a:prstGeom prst="rect">
              <a:avLst/>
            </a:prstGeom>
          </p:spPr>
        </p:pic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id="{93C3E098-629C-4761-A968-ABBA3D74F9D0}"/>
                </a:ext>
              </a:extLst>
            </p:cNvPr>
            <p:cNvCxnSpPr/>
            <p:nvPr/>
          </p:nvCxnSpPr>
          <p:spPr>
            <a:xfrm>
              <a:off x="0" y="2094411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DD4BB599-BCE8-6FB6-ECB1-150E3432C043}"/>
                </a:ext>
              </a:extLst>
            </p:cNvPr>
            <p:cNvSpPr txBox="1"/>
            <p:nvPr/>
          </p:nvSpPr>
          <p:spPr>
            <a:xfrm>
              <a:off x="123378" y="6396179"/>
              <a:ext cx="526777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Figure 3B Pou3f1 and GAPDH (RAW264.7 cells)</a:t>
              </a:r>
              <a:endParaRPr lang="zh-CN" altLang="en-US" b="1" dirty="0"/>
            </a:p>
          </p:txBody>
        </p: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CA7A2D1A-1179-9670-EB45-6BE213884A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93988" y="2425066"/>
              <a:ext cx="1702738" cy="1254438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BF6C6A4E-A0A2-3618-0097-3CB7715753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81017" y="2482231"/>
              <a:ext cx="1702738" cy="1151400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47D9E6C3-8288-8A5A-FE49-7DB45D9667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93988" y="4323766"/>
              <a:ext cx="1738777" cy="1673231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2A5CF49E-7AC4-1902-BC79-C1981440F1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281017" y="4509443"/>
              <a:ext cx="2492159" cy="1301875"/>
            </a:xfrm>
            <a:prstGeom prst="rect">
              <a:avLst/>
            </a:prstGeom>
          </p:spPr>
        </p:pic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C8FBFE4-5360-2A0C-D04A-2F22C2E655F4}"/>
                </a:ext>
              </a:extLst>
            </p:cNvPr>
            <p:cNvSpPr txBox="1"/>
            <p:nvPr/>
          </p:nvSpPr>
          <p:spPr>
            <a:xfrm>
              <a:off x="232430" y="983145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56AE41BE-9B6A-9270-C640-D86614A38517}"/>
                </a:ext>
              </a:extLst>
            </p:cNvPr>
            <p:cNvSpPr txBox="1"/>
            <p:nvPr/>
          </p:nvSpPr>
          <p:spPr>
            <a:xfrm>
              <a:off x="4993640" y="983145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549A7E67-1258-F1EB-49CB-F7DA6B2B49C8}"/>
                </a:ext>
              </a:extLst>
            </p:cNvPr>
            <p:cNvCxnSpPr/>
            <p:nvPr/>
          </p:nvCxnSpPr>
          <p:spPr>
            <a:xfrm>
              <a:off x="27216" y="4046583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94E0B20A-A32B-A684-8B43-4BD3A027C517}"/>
                </a:ext>
              </a:extLst>
            </p:cNvPr>
            <p:cNvSpPr txBox="1"/>
            <p:nvPr/>
          </p:nvSpPr>
          <p:spPr>
            <a:xfrm>
              <a:off x="148772" y="2885311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3EC64995-D400-522E-BD84-00783D6DCB61}"/>
                </a:ext>
              </a:extLst>
            </p:cNvPr>
            <p:cNvSpPr txBox="1"/>
            <p:nvPr/>
          </p:nvSpPr>
          <p:spPr>
            <a:xfrm>
              <a:off x="4909982" y="2885311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5527EDF5-3EDB-9FF2-771D-F302D40C0562}"/>
                </a:ext>
              </a:extLst>
            </p:cNvPr>
            <p:cNvSpPr txBox="1"/>
            <p:nvPr/>
          </p:nvSpPr>
          <p:spPr>
            <a:xfrm>
              <a:off x="185218" y="5052104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4055E14A-22ED-E08F-AB4B-61E050A56F45}"/>
                </a:ext>
              </a:extLst>
            </p:cNvPr>
            <p:cNvSpPr txBox="1"/>
            <p:nvPr/>
          </p:nvSpPr>
          <p:spPr>
            <a:xfrm>
              <a:off x="4946428" y="5052104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13328232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C3933730-ED8F-08C0-FDA3-31E492A537E2}"/>
              </a:ext>
            </a:extLst>
          </p:cNvPr>
          <p:cNvGrpSpPr/>
          <p:nvPr/>
        </p:nvGrpSpPr>
        <p:grpSpPr>
          <a:xfrm>
            <a:off x="-93982" y="641906"/>
            <a:ext cx="10040622" cy="6123605"/>
            <a:chOff x="-93982" y="641906"/>
            <a:chExt cx="10040622" cy="6123605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2675A686-2BC0-4D97-A6F6-61E42A041A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90544" y="641906"/>
              <a:ext cx="1659860" cy="1152348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ED9F04E7-964B-4B4C-AE56-73422A13C6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64516" y="736073"/>
              <a:ext cx="1950940" cy="876929"/>
            </a:xfrm>
            <a:prstGeom prst="rect">
              <a:avLst/>
            </a:prstGeom>
          </p:spPr>
        </p:pic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id="{93C3E098-629C-4761-A968-ABBA3D74F9D0}"/>
                </a:ext>
              </a:extLst>
            </p:cNvPr>
            <p:cNvCxnSpPr/>
            <p:nvPr/>
          </p:nvCxnSpPr>
          <p:spPr>
            <a:xfrm>
              <a:off x="-93982" y="2297612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DD4BB599-BCE8-6FB6-ECB1-150E3432C043}"/>
                </a:ext>
              </a:extLst>
            </p:cNvPr>
            <p:cNvSpPr txBox="1"/>
            <p:nvPr/>
          </p:nvSpPr>
          <p:spPr>
            <a:xfrm>
              <a:off x="123379" y="6396179"/>
              <a:ext cx="482962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Figure 3B Pou3f1 and GAPDH (BMDMs)</a:t>
              </a:r>
              <a:endParaRPr lang="zh-CN" altLang="en-US" b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E497C5FE-538F-1EC8-6B77-8D99C067679C}"/>
                </a:ext>
              </a:extLst>
            </p:cNvPr>
            <p:cNvSpPr txBox="1"/>
            <p:nvPr/>
          </p:nvSpPr>
          <p:spPr>
            <a:xfrm>
              <a:off x="232430" y="983145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12F74AD5-92C2-BD4A-8400-2660ABB9228B}"/>
                </a:ext>
              </a:extLst>
            </p:cNvPr>
            <p:cNvSpPr txBox="1"/>
            <p:nvPr/>
          </p:nvSpPr>
          <p:spPr>
            <a:xfrm>
              <a:off x="4993640" y="983145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B09603FC-4845-39AE-5965-B4FED8B325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90544" y="2760277"/>
              <a:ext cx="2244560" cy="1152348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C7C995AC-18D0-0F83-953E-52AEB54970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64516" y="2666569"/>
              <a:ext cx="1488299" cy="1246056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82D7618A-F227-7375-A176-04C5EB1806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90544" y="4901133"/>
              <a:ext cx="1740458" cy="1152348"/>
            </a:xfrm>
            <a:prstGeom prst="rect">
              <a:avLst/>
            </a:prstGeom>
          </p:spPr>
        </p:pic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C6FA07A6-628D-9C55-70F6-48833CB15A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63966" y="5040299"/>
              <a:ext cx="1951490" cy="874016"/>
            </a:xfrm>
            <a:prstGeom prst="rect">
              <a:avLst/>
            </a:prstGeom>
          </p:spPr>
        </p:pic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2948307B-6A30-ADBB-1FDC-2B88B1D97C62}"/>
                </a:ext>
              </a:extLst>
            </p:cNvPr>
            <p:cNvCxnSpPr/>
            <p:nvPr/>
          </p:nvCxnSpPr>
          <p:spPr>
            <a:xfrm>
              <a:off x="-40640" y="4438469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C04D6FA0-CEDA-F964-F643-1DB5B8E706F3}"/>
                </a:ext>
              </a:extLst>
            </p:cNvPr>
            <p:cNvSpPr txBox="1"/>
            <p:nvPr/>
          </p:nvSpPr>
          <p:spPr>
            <a:xfrm>
              <a:off x="232430" y="3145964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6D6F07FC-1D64-6653-BB34-E74381EC7552}"/>
                </a:ext>
              </a:extLst>
            </p:cNvPr>
            <p:cNvSpPr txBox="1"/>
            <p:nvPr/>
          </p:nvSpPr>
          <p:spPr>
            <a:xfrm>
              <a:off x="4993640" y="3145964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9D5CC7C8-C30A-51BE-60C8-5192246D53BC}"/>
                </a:ext>
              </a:extLst>
            </p:cNvPr>
            <p:cNvSpPr txBox="1"/>
            <p:nvPr/>
          </p:nvSpPr>
          <p:spPr>
            <a:xfrm>
              <a:off x="191790" y="5294632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BC4A488C-CEBA-BAB8-D8EA-9B3CB700D013}"/>
                </a:ext>
              </a:extLst>
            </p:cNvPr>
            <p:cNvSpPr txBox="1"/>
            <p:nvPr/>
          </p:nvSpPr>
          <p:spPr>
            <a:xfrm>
              <a:off x="4953000" y="5294632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5854996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22E7F241-EE5B-5A55-1068-CB50472123DD}"/>
              </a:ext>
            </a:extLst>
          </p:cNvPr>
          <p:cNvGrpSpPr/>
          <p:nvPr/>
        </p:nvGrpSpPr>
        <p:grpSpPr>
          <a:xfrm>
            <a:off x="-93982" y="524200"/>
            <a:ext cx="10040622" cy="6241311"/>
            <a:chOff x="-93982" y="524200"/>
            <a:chExt cx="10040622" cy="6241311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C9B38717-0B00-8488-57DF-1403354070C6}"/>
                </a:ext>
              </a:extLst>
            </p:cNvPr>
            <p:cNvSpPr txBox="1"/>
            <p:nvPr/>
          </p:nvSpPr>
          <p:spPr>
            <a:xfrm>
              <a:off x="123379" y="6396179"/>
              <a:ext cx="487026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Figure 3D Pou3f1 and GAPDH (RAW264.7 cells)</a:t>
              </a:r>
              <a:endParaRPr lang="zh-CN" altLang="en-US" b="1" dirty="0"/>
            </a:p>
          </p:txBody>
        </p:sp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C1BC54BF-44A6-F837-BA66-BB46F66DC3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30692" y="524200"/>
              <a:ext cx="2830002" cy="1224145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A6308B1B-4891-4DF1-5B2E-07E2AA9203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55285" y="524200"/>
              <a:ext cx="2680201" cy="1224145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2857A180-7A43-CE6A-F597-28E107A964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30692" y="2465856"/>
              <a:ext cx="2153113" cy="1701100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62592352-BEC3-7290-97AE-09DD14FD25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64708" y="2465856"/>
              <a:ext cx="2429760" cy="1701100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8A8DBDC8-124C-954D-603A-9D3C175408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30692" y="4743444"/>
              <a:ext cx="2683771" cy="1381221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41928F35-E03A-184A-4926-A45FD2B2E6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64708" y="4906178"/>
              <a:ext cx="2901678" cy="1116178"/>
            </a:xfrm>
            <a:prstGeom prst="rect">
              <a:avLst/>
            </a:prstGeom>
          </p:spPr>
        </p:pic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7829481B-34F1-FBA2-84C0-F5C746B4A2F1}"/>
                </a:ext>
              </a:extLst>
            </p:cNvPr>
            <p:cNvCxnSpPr/>
            <p:nvPr/>
          </p:nvCxnSpPr>
          <p:spPr>
            <a:xfrm>
              <a:off x="-93982" y="2297612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B6354DA1-BA98-1F64-C972-C13F1BDB7A07}"/>
                </a:ext>
              </a:extLst>
            </p:cNvPr>
            <p:cNvCxnSpPr/>
            <p:nvPr/>
          </p:nvCxnSpPr>
          <p:spPr>
            <a:xfrm>
              <a:off x="-40640" y="4438469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771C1D36-7E21-F049-3648-75683F3E1C62}"/>
                </a:ext>
              </a:extLst>
            </p:cNvPr>
            <p:cNvSpPr txBox="1"/>
            <p:nvPr/>
          </p:nvSpPr>
          <p:spPr>
            <a:xfrm>
              <a:off x="232430" y="983145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ABE800F1-67CE-67CD-0EE6-36865CB99246}"/>
                </a:ext>
              </a:extLst>
            </p:cNvPr>
            <p:cNvSpPr txBox="1"/>
            <p:nvPr/>
          </p:nvSpPr>
          <p:spPr>
            <a:xfrm>
              <a:off x="4993640" y="983145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917BA693-F65D-8C2A-2F68-0C11B6B1AE95}"/>
                </a:ext>
              </a:extLst>
            </p:cNvPr>
            <p:cNvSpPr txBox="1"/>
            <p:nvPr/>
          </p:nvSpPr>
          <p:spPr>
            <a:xfrm>
              <a:off x="232430" y="3205078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703B1989-47B7-FAF9-DBB2-4D9E1E4E31DE}"/>
                </a:ext>
              </a:extLst>
            </p:cNvPr>
            <p:cNvSpPr txBox="1"/>
            <p:nvPr/>
          </p:nvSpPr>
          <p:spPr>
            <a:xfrm>
              <a:off x="4993640" y="3205078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913947CB-8EB1-BAD4-B141-3E5434571CEC}"/>
                </a:ext>
              </a:extLst>
            </p:cNvPr>
            <p:cNvSpPr txBox="1"/>
            <p:nvPr/>
          </p:nvSpPr>
          <p:spPr>
            <a:xfrm>
              <a:off x="232430" y="5252205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2203AF3-2357-D7FD-559B-662390C43025}"/>
                </a:ext>
              </a:extLst>
            </p:cNvPr>
            <p:cNvSpPr txBox="1"/>
            <p:nvPr/>
          </p:nvSpPr>
          <p:spPr>
            <a:xfrm>
              <a:off x="4993640" y="5252205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6034481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4AD77AB8-DE38-1FDC-77E4-4B8786458524}"/>
              </a:ext>
            </a:extLst>
          </p:cNvPr>
          <p:cNvGrpSpPr/>
          <p:nvPr/>
        </p:nvGrpSpPr>
        <p:grpSpPr>
          <a:xfrm>
            <a:off x="-93982" y="339903"/>
            <a:ext cx="10040622" cy="6425608"/>
            <a:chOff x="-93982" y="339903"/>
            <a:chExt cx="10040622" cy="6425608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C9B38717-0B00-8488-57DF-1403354070C6}"/>
                </a:ext>
              </a:extLst>
            </p:cNvPr>
            <p:cNvSpPr txBox="1"/>
            <p:nvPr/>
          </p:nvSpPr>
          <p:spPr>
            <a:xfrm>
              <a:off x="123379" y="6396179"/>
              <a:ext cx="454387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b="1" dirty="0"/>
                <a:t>Figure 3D Pou3f1 and GAPDH (BMDMs)</a:t>
              </a:r>
              <a:endParaRPr lang="zh-CN" altLang="en-US" b="1" dirty="0"/>
            </a:p>
          </p:txBody>
        </p: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6AD46FDC-BF8A-3160-5A3C-B4AE58EBA2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64424" y="339903"/>
              <a:ext cx="1632125" cy="1800629"/>
            </a:xfrm>
            <a:prstGeom prst="rect">
              <a:avLst/>
            </a:prstGeom>
          </p:spPr>
        </p:pic>
        <p:cxnSp>
          <p:nvCxnSpPr>
            <p:cNvPr id="5" name="直接连接符 4">
              <a:extLst>
                <a:ext uri="{FF2B5EF4-FFF2-40B4-BE49-F238E27FC236}">
                  <a16:creationId xmlns:a16="http://schemas.microsoft.com/office/drawing/2014/main" id="{A7D1855C-E37E-95E2-56AE-05CED9F02973}"/>
                </a:ext>
              </a:extLst>
            </p:cNvPr>
            <p:cNvCxnSpPr/>
            <p:nvPr/>
          </p:nvCxnSpPr>
          <p:spPr>
            <a:xfrm>
              <a:off x="-93982" y="2297612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直接连接符 5">
              <a:extLst>
                <a:ext uri="{FF2B5EF4-FFF2-40B4-BE49-F238E27FC236}">
                  <a16:creationId xmlns:a16="http://schemas.microsoft.com/office/drawing/2014/main" id="{83CB7F20-5854-8F9F-4CC7-091285E1ECB7}"/>
                </a:ext>
              </a:extLst>
            </p:cNvPr>
            <p:cNvCxnSpPr/>
            <p:nvPr/>
          </p:nvCxnSpPr>
          <p:spPr>
            <a:xfrm>
              <a:off x="-40640" y="4438469"/>
              <a:ext cx="9987280" cy="0"/>
            </a:xfrm>
            <a:prstGeom prst="line">
              <a:avLst/>
            </a:prstGeom>
            <a:ln>
              <a:prstDash val="lgDashDot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7E3571E1-9C15-EEFE-3621-5E32F66A9996}"/>
                </a:ext>
              </a:extLst>
            </p:cNvPr>
            <p:cNvSpPr txBox="1"/>
            <p:nvPr/>
          </p:nvSpPr>
          <p:spPr>
            <a:xfrm>
              <a:off x="232430" y="983145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ECB36128-F174-70E5-B82A-BA72DAA60D22}"/>
                </a:ext>
              </a:extLst>
            </p:cNvPr>
            <p:cNvSpPr txBox="1"/>
            <p:nvPr/>
          </p:nvSpPr>
          <p:spPr>
            <a:xfrm>
              <a:off x="4993640" y="983145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C9A34155-8CAB-4CF6-A7C6-2E0A232A4670}"/>
                </a:ext>
              </a:extLst>
            </p:cNvPr>
            <p:cNvSpPr txBox="1"/>
            <p:nvPr/>
          </p:nvSpPr>
          <p:spPr>
            <a:xfrm>
              <a:off x="232430" y="3205078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469122B1-6598-F1F2-801D-91E807328914}"/>
                </a:ext>
              </a:extLst>
            </p:cNvPr>
            <p:cNvSpPr txBox="1"/>
            <p:nvPr/>
          </p:nvSpPr>
          <p:spPr>
            <a:xfrm>
              <a:off x="4993640" y="3205078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D695122E-4CF7-1021-04C8-1E8270BCFD71}"/>
                </a:ext>
              </a:extLst>
            </p:cNvPr>
            <p:cNvSpPr txBox="1"/>
            <p:nvPr/>
          </p:nvSpPr>
          <p:spPr>
            <a:xfrm>
              <a:off x="232430" y="5252205"/>
              <a:ext cx="1632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Pou3f1 (45kD) </a:t>
              </a:r>
              <a:endParaRPr lang="zh-CN" altLang="en-US" sz="1600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4F9636E3-6D8F-486D-39A4-0114CF51EF2A}"/>
                </a:ext>
              </a:extLst>
            </p:cNvPr>
            <p:cNvSpPr txBox="1"/>
            <p:nvPr/>
          </p:nvSpPr>
          <p:spPr>
            <a:xfrm>
              <a:off x="4993640" y="5252205"/>
              <a:ext cx="17754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/>
                <a:t>GAPDH (36kD)</a:t>
              </a:r>
              <a:endParaRPr lang="zh-CN" altLang="en-US" sz="1600" dirty="0"/>
            </a:p>
          </p:txBody>
        </p:sp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C0542B0A-7E9F-EE5C-666E-9BEB7BE02C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86739" y="808244"/>
              <a:ext cx="1479791" cy="684290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88F46460-80CF-774A-48E3-393DBAB530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64424" y="2753338"/>
              <a:ext cx="2494651" cy="1257658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C59F0C1E-89B3-F587-2B63-4673A85907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86739" y="2660109"/>
              <a:ext cx="2494651" cy="1428491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FD595B1A-ED02-023E-BADF-FB0F7BF47D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64424" y="4581441"/>
              <a:ext cx="2650499" cy="1800620"/>
            </a:xfrm>
            <a:prstGeom prst="rect">
              <a:avLst/>
            </a:prstGeom>
          </p:spPr>
        </p:pic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4700F594-0D84-C445-1DB8-9B46DFBEEE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386739" y="4811980"/>
              <a:ext cx="2003966" cy="133954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5873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9</TotalTime>
  <Words>703</Words>
  <PresentationFormat>A4 纸张(210x297 毫米)</PresentationFormat>
  <Paragraphs>182</Paragraphs>
  <Slides>20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0</vt:i4>
      </vt:variant>
    </vt:vector>
  </HeadingPairs>
  <TitlesOfParts>
    <vt:vector size="25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12-21T00:56:49Z</dcterms:created>
  <dcterms:modified xsi:type="dcterms:W3CDTF">2022-07-30T08:16:48Z</dcterms:modified>
</cp:coreProperties>
</file>